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2" r:id="rId4"/>
  </p:sldMasterIdLst>
  <p:notesMasterIdLst>
    <p:notesMasterId r:id="rId6"/>
  </p:notesMasterIdLst>
  <p:handoutMasterIdLst>
    <p:handoutMasterId r:id="rId7"/>
  </p:handoutMasterIdLst>
  <p:sldIdLst>
    <p:sldId id="2147473198" r:id="rId5"/>
  </p:sldIdLst>
  <p:sldSz cx="7772400" cy="10058400"/>
  <p:notesSz cx="9236075" cy="6950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C47B904-6140-183F-6626-810AD941BC5F}" name="sandro vivona" initials="sv" userId="d84a23f2ce15348e" providerId="Windows Live"/>
  <p188:author id="{6640730D-E668-EBD7-4D88-59444B821699}" name="Han Zhang" initials="HZ" userId="S::hzhang@synthekine.com::6317fe23-ee67-4a69-90de-ce2827b9cc80" providerId="AD"/>
  <p188:author id="{D3D1A540-3B41-77EB-C4FF-DB03FE601775}" name="Raphael Trenker" initials="" userId="S::rtrenker@synthekine.com::3cf2b6e2-e4ff-452e-b146-352e1ebd163a" providerId="AD"/>
  <p188:author id="{396D694D-04F2-E198-EF7C-69907BF6F97F}" name="Patrick Lupardus" initials="" userId="S::plupardus@synthekine.com::e7ee2082-4c19-49db-bd96-8945a1678ecb" providerId="AD"/>
  <p188:author id="{9E8B984D-81FF-2856-865B-B81E5AB36BDE}" name="Sandro Vivona" initials="SV" userId="S::svivona@synthekine.com::f239ceec-585a-4529-8149-38ad9af329f7" providerId="AD"/>
  <p188:author id="{85292871-54B9-12E4-2FFF-7A4DF67940A6}" name="Nathan Revel" initials="NR" userId="S::nrevel@synthekine.com::f264019f-14df-40c7-a112-9829caf1f08c" providerId="AD"/>
  <p188:author id="{8954D5BD-3741-0E1C-04AA-68A9D70F4BEF}" name="Priyanka Balasubrahmanyam" initials="" userId="S::pbalasubrahmanyam@synthekine.com::9589aa79-b0b1-4216-997c-831c3058882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07E3"/>
    <a:srgbClr val="FF8000"/>
    <a:srgbClr val="0000FF"/>
    <a:srgbClr val="027F02"/>
    <a:srgbClr val="FF0000"/>
    <a:srgbClr val="00C000"/>
    <a:srgbClr val="FFFFFF"/>
    <a:srgbClr val="847D00"/>
    <a:srgbClr val="000097"/>
    <a:srgbClr val="FB80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385"/>
    <p:restoredTop sz="94658"/>
  </p:normalViewPr>
  <p:slideViewPr>
    <p:cSldViewPr snapToGrid="0">
      <p:cViewPr varScale="1">
        <p:scale>
          <a:sx n="45" d="100"/>
          <a:sy n="45" d="100"/>
        </p:scale>
        <p:origin x="1934" y="3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DC895CBC-0168-4550-BFFB-F83D9CCD5E9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1" y="0"/>
            <a:ext cx="4002299" cy="348711"/>
          </a:xfrm>
          <a:prstGeom prst="rect">
            <a:avLst/>
          </a:prstGeom>
        </p:spPr>
        <p:txBody>
          <a:bodyPr vert="horz" lIns="92486" tIns="46242" rIns="92486" bIns="4624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B94021-185F-44CB-81E7-50AD44AF95E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231640" y="0"/>
            <a:ext cx="4002299" cy="348711"/>
          </a:xfrm>
          <a:prstGeom prst="rect">
            <a:avLst/>
          </a:prstGeom>
        </p:spPr>
        <p:txBody>
          <a:bodyPr vert="horz" lIns="92486" tIns="46242" rIns="92486" bIns="46242" rtlCol="0"/>
          <a:lstStyle>
            <a:lvl1pPr algn="r">
              <a:defRPr sz="1200"/>
            </a:lvl1pPr>
          </a:lstStyle>
          <a:p>
            <a:fld id="{7ED2F072-0FE2-4749-AE83-E47BB0C66CD7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53821B-16A3-4C18-8090-8193D98BC26F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1" y="6601366"/>
            <a:ext cx="4002299" cy="348710"/>
          </a:xfrm>
          <a:prstGeom prst="rect">
            <a:avLst/>
          </a:prstGeom>
        </p:spPr>
        <p:txBody>
          <a:bodyPr vert="horz" lIns="92486" tIns="46242" rIns="92486" bIns="4624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DB3D9D-7024-4041-9660-981DEEED853A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231640" y="6601366"/>
            <a:ext cx="4002299" cy="348710"/>
          </a:xfrm>
          <a:prstGeom prst="rect">
            <a:avLst/>
          </a:prstGeom>
        </p:spPr>
        <p:txBody>
          <a:bodyPr vert="horz" lIns="92486" tIns="46242" rIns="92486" bIns="46242" rtlCol="0" anchor="b"/>
          <a:lstStyle>
            <a:lvl1pPr algn="r">
              <a:defRPr sz="1200"/>
            </a:lvl1pPr>
          </a:lstStyle>
          <a:p>
            <a:fld id="{4251B358-EBAD-4E75-8E6A-F2BA61A3D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3808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02299" cy="348711"/>
          </a:xfrm>
          <a:prstGeom prst="rect">
            <a:avLst/>
          </a:prstGeom>
        </p:spPr>
        <p:txBody>
          <a:bodyPr vert="horz" lIns="92486" tIns="46242" rIns="92486" bIns="4624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31640" y="0"/>
            <a:ext cx="4002299" cy="348711"/>
          </a:xfrm>
          <a:prstGeom prst="rect">
            <a:avLst/>
          </a:prstGeom>
        </p:spPr>
        <p:txBody>
          <a:bodyPr vert="horz" lIns="92486" tIns="46242" rIns="92486" bIns="46242" rtlCol="0"/>
          <a:lstStyle>
            <a:lvl1pPr algn="r">
              <a:defRPr sz="1200"/>
            </a:lvl1pPr>
          </a:lstStyle>
          <a:p>
            <a:fld id="{694C53CB-F830-304B-ABE7-51F783E449A2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11575" y="868363"/>
            <a:ext cx="1812925" cy="2346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86" tIns="46242" rIns="92486" bIns="4624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3608" y="3344724"/>
            <a:ext cx="7388860" cy="2736592"/>
          </a:xfrm>
          <a:prstGeom prst="rect">
            <a:avLst/>
          </a:prstGeom>
        </p:spPr>
        <p:txBody>
          <a:bodyPr vert="horz" lIns="92486" tIns="46242" rIns="92486" bIns="4624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601366"/>
            <a:ext cx="4002299" cy="348710"/>
          </a:xfrm>
          <a:prstGeom prst="rect">
            <a:avLst/>
          </a:prstGeom>
        </p:spPr>
        <p:txBody>
          <a:bodyPr vert="horz" lIns="92486" tIns="46242" rIns="92486" bIns="4624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31640" y="6601366"/>
            <a:ext cx="4002299" cy="348710"/>
          </a:xfrm>
          <a:prstGeom prst="rect">
            <a:avLst/>
          </a:prstGeom>
        </p:spPr>
        <p:txBody>
          <a:bodyPr vert="horz" lIns="92486" tIns="46242" rIns="92486" bIns="46242" rtlCol="0" anchor="b"/>
          <a:lstStyle>
            <a:lvl1pPr algn="r">
              <a:defRPr sz="1200"/>
            </a:lvl1pPr>
          </a:lstStyle>
          <a:p>
            <a:fld id="{6C85F3C5-FAC1-3041-995B-A2A777D4B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268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jpeg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1.png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4.png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microsoft.com/office/2007/relationships/hdphoto" Target="../media/hdphoto1.wdp"/></Relationships>
</file>

<file path=ppt/slideLayouts/_rels/slideLayout17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126426"/>
      </p:ext>
    </p:extLst>
  </p:cSld>
  <p:clrMapOvr>
    <a:masterClrMapping/>
  </p:clrMapOvr>
  <p:hf hd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193038"/>
      </p:ext>
    </p:extLst>
  </p:cSld>
  <p:clrMapOvr>
    <a:masterClrMapping/>
  </p:clrMapOvr>
  <p:hf hd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665327"/>
      </p:ext>
    </p:extLst>
  </p:cSld>
  <p:clrMapOvr>
    <a:masterClrMapping/>
  </p:clrMapOvr>
  <p:hf hd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Custom Layou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13">
            <a:extLst>
              <a:ext uri="{FF2B5EF4-FFF2-40B4-BE49-F238E27FC236}">
                <a16:creationId xmlns:a16="http://schemas.microsoft.com/office/drawing/2014/main" id="{056203DA-80D4-9449-A0DF-EBC662B3B854}"/>
              </a:ext>
            </a:extLst>
          </p:cNvPr>
          <p:cNvSpPr/>
          <p:nvPr userDrawn="1"/>
        </p:nvSpPr>
        <p:spPr>
          <a:xfrm>
            <a:off x="1" y="-38872"/>
            <a:ext cx="5434139" cy="10177848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4000">
                <a:srgbClr val="00AC69"/>
              </a:gs>
              <a:gs pos="100000">
                <a:srgbClr val="00ACD9">
                  <a:shade val="100000"/>
                  <a:satMod val="115000"/>
                </a:srgbClr>
              </a:gs>
            </a:gsLst>
            <a:lin ang="2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837FBB0-1B61-0849-89A7-5F58A4CB3DD3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alphaModFix amt="50000"/>
          </a:blip>
          <a:srcRect/>
          <a:stretch/>
        </p:blipFill>
        <p:spPr>
          <a:xfrm>
            <a:off x="-960203" y="1784403"/>
            <a:ext cx="5104212" cy="10713421"/>
          </a:xfrm>
          <a:prstGeom prst="rect">
            <a:avLst/>
          </a:prstGeom>
        </p:spPr>
      </p:pic>
      <p:sp>
        <p:nvSpPr>
          <p:cNvPr id="12" name="Rectangle 13">
            <a:extLst>
              <a:ext uri="{FF2B5EF4-FFF2-40B4-BE49-F238E27FC236}">
                <a16:creationId xmlns:a16="http://schemas.microsoft.com/office/drawing/2014/main" id="{D3A68B16-900F-8B41-AD87-B9B09D6D5AE5}"/>
              </a:ext>
            </a:extLst>
          </p:cNvPr>
          <p:cNvSpPr/>
          <p:nvPr userDrawn="1"/>
        </p:nvSpPr>
        <p:spPr>
          <a:xfrm>
            <a:off x="-16896" y="-38872"/>
            <a:ext cx="5515897" cy="5279997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0">
                <a:srgbClr val="003348">
                  <a:alpha val="68971"/>
                </a:srgbClr>
              </a:gs>
              <a:gs pos="90000">
                <a:srgbClr val="003348">
                  <a:alpha val="0"/>
                </a:srgbClr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B1378F1-9C26-4E45-B14E-F2B9E3922703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rcRect/>
          <a:stretch/>
        </p:blipFill>
        <p:spPr>
          <a:xfrm>
            <a:off x="217590" y="509621"/>
            <a:ext cx="2694820" cy="1653291"/>
          </a:xfrm>
          <a:prstGeom prst="rect">
            <a:avLst/>
          </a:prstGeom>
        </p:spPr>
      </p:pic>
      <p:sp>
        <p:nvSpPr>
          <p:cNvPr id="5" name="Freeform 4">
            <a:extLst>
              <a:ext uri="{FF2B5EF4-FFF2-40B4-BE49-F238E27FC236}">
                <a16:creationId xmlns:a16="http://schemas.microsoft.com/office/drawing/2014/main" id="{8B568D2B-3EA9-6B4E-9125-900BD23544E8}"/>
              </a:ext>
            </a:extLst>
          </p:cNvPr>
          <p:cNvSpPr/>
          <p:nvPr userDrawn="1"/>
        </p:nvSpPr>
        <p:spPr>
          <a:xfrm>
            <a:off x="2521891" y="-47345"/>
            <a:ext cx="5796790" cy="10173353"/>
          </a:xfrm>
          <a:custGeom>
            <a:avLst/>
            <a:gdLst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104811"/>
              <a:gd name="connsiteY0" fmla="*/ 0 h 6936377"/>
              <a:gd name="connsiteX1" fmla="*/ 4441371 w 9104811"/>
              <a:gd name="connsiteY1" fmla="*/ 6936377 h 6936377"/>
              <a:gd name="connsiteX2" fmla="*/ 9091748 w 9104811"/>
              <a:gd name="connsiteY2" fmla="*/ 6897189 h 6936377"/>
              <a:gd name="connsiteX3" fmla="*/ 9104811 w 9104811"/>
              <a:gd name="connsiteY3" fmla="*/ 39189 h 6936377"/>
              <a:gd name="connsiteX4" fmla="*/ 0 w 9104811"/>
              <a:gd name="connsiteY4" fmla="*/ 0 h 6936377"/>
              <a:gd name="connsiteX0" fmla="*/ 0 w 9093004"/>
              <a:gd name="connsiteY0" fmla="*/ 0 h 6936377"/>
              <a:gd name="connsiteX1" fmla="*/ 4441371 w 9093004"/>
              <a:gd name="connsiteY1" fmla="*/ 6936377 h 6936377"/>
              <a:gd name="connsiteX2" fmla="*/ 9091748 w 9093004"/>
              <a:gd name="connsiteY2" fmla="*/ 6897189 h 6936377"/>
              <a:gd name="connsiteX3" fmla="*/ 9091748 w 9093004"/>
              <a:gd name="connsiteY3" fmla="*/ 13063 h 6936377"/>
              <a:gd name="connsiteX4" fmla="*/ 0 w 9093004"/>
              <a:gd name="connsiteY4" fmla="*/ 0 h 69363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093004" h="6936377">
                <a:moveTo>
                  <a:pt x="0" y="0"/>
                </a:moveTo>
                <a:cubicBezTo>
                  <a:pt x="2486297" y="2747554"/>
                  <a:pt x="2804161" y="3705497"/>
                  <a:pt x="4441371" y="6936377"/>
                </a:cubicBezTo>
                <a:lnTo>
                  <a:pt x="9091748" y="6897189"/>
                </a:lnTo>
                <a:cubicBezTo>
                  <a:pt x="9096102" y="4611189"/>
                  <a:pt x="9087394" y="2299063"/>
                  <a:pt x="9091748" y="13063"/>
                </a:cubicBezTo>
                <a:lnTo>
                  <a:pt x="0" y="0"/>
                </a:lnTo>
                <a:close/>
              </a:path>
            </a:pathLst>
          </a:custGeom>
          <a:blipFill dpi="0" rotWithShape="1">
            <a:blip r:embed="rId4"/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4" name="Picture Placeholder 13">
            <a:extLst>
              <a:ext uri="{FF2B5EF4-FFF2-40B4-BE49-F238E27FC236}">
                <a16:creationId xmlns:a16="http://schemas.microsoft.com/office/drawing/2014/main" id="{E6E73466-34DB-A447-8C04-3128F6FA2F4A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2509220" y="-19438"/>
            <a:ext cx="5795420" cy="10194457"/>
          </a:xfrm>
          <a:custGeom>
            <a:avLst/>
            <a:gdLst>
              <a:gd name="connsiteX0" fmla="*/ 0 w 9196871"/>
              <a:gd name="connsiteY0" fmla="*/ 0 h 6858000"/>
              <a:gd name="connsiteX1" fmla="*/ 9196871 w 9196871"/>
              <a:gd name="connsiteY1" fmla="*/ 0 h 6858000"/>
              <a:gd name="connsiteX2" fmla="*/ 9196871 w 9196871"/>
              <a:gd name="connsiteY2" fmla="*/ 6858000 h 6858000"/>
              <a:gd name="connsiteX3" fmla="*/ 0 w 9196871"/>
              <a:gd name="connsiteY3" fmla="*/ 6858000 h 6858000"/>
              <a:gd name="connsiteX4" fmla="*/ 0 w 9196871"/>
              <a:gd name="connsiteY4" fmla="*/ 0 h 6858000"/>
              <a:gd name="connsiteX0" fmla="*/ 0 w 9196871"/>
              <a:gd name="connsiteY0" fmla="*/ 0 h 6884504"/>
              <a:gd name="connsiteX1" fmla="*/ 9196871 w 9196871"/>
              <a:gd name="connsiteY1" fmla="*/ 0 h 6884504"/>
              <a:gd name="connsiteX2" fmla="*/ 9196871 w 9196871"/>
              <a:gd name="connsiteY2" fmla="*/ 6858000 h 6884504"/>
              <a:gd name="connsiteX3" fmla="*/ 2955235 w 9196871"/>
              <a:gd name="connsiteY3" fmla="*/ 6884504 h 6884504"/>
              <a:gd name="connsiteX4" fmla="*/ 0 w 9196871"/>
              <a:gd name="connsiteY4" fmla="*/ 0 h 6884504"/>
              <a:gd name="connsiteX0" fmla="*/ 0 w 9196871"/>
              <a:gd name="connsiteY0" fmla="*/ 0 h 8235263"/>
              <a:gd name="connsiteX1" fmla="*/ 9196871 w 9196871"/>
              <a:gd name="connsiteY1" fmla="*/ 0 h 8235263"/>
              <a:gd name="connsiteX2" fmla="*/ 9196871 w 9196871"/>
              <a:gd name="connsiteY2" fmla="*/ 6858000 h 8235263"/>
              <a:gd name="connsiteX3" fmla="*/ 2955235 w 9196871"/>
              <a:gd name="connsiteY3" fmla="*/ 6884504 h 8235263"/>
              <a:gd name="connsiteX4" fmla="*/ 0 w 9196871"/>
              <a:gd name="connsiteY4" fmla="*/ 0 h 8235263"/>
              <a:gd name="connsiteX0" fmla="*/ 323336 w 9520207"/>
              <a:gd name="connsiteY0" fmla="*/ 0 h 8235263"/>
              <a:gd name="connsiteX1" fmla="*/ 9520207 w 9520207"/>
              <a:gd name="connsiteY1" fmla="*/ 0 h 8235263"/>
              <a:gd name="connsiteX2" fmla="*/ 9520207 w 9520207"/>
              <a:gd name="connsiteY2" fmla="*/ 6858000 h 8235263"/>
              <a:gd name="connsiteX3" fmla="*/ 3278571 w 9520207"/>
              <a:gd name="connsiteY3" fmla="*/ 6884504 h 8235263"/>
              <a:gd name="connsiteX4" fmla="*/ 2191755 w 9520207"/>
              <a:gd name="connsiteY4" fmla="*/ 3498574 h 8235263"/>
              <a:gd name="connsiteX5" fmla="*/ 323336 w 9520207"/>
              <a:gd name="connsiteY5" fmla="*/ 0 h 8235263"/>
              <a:gd name="connsiteX0" fmla="*/ 0 w 9196871"/>
              <a:gd name="connsiteY0" fmla="*/ 0 h 8235263"/>
              <a:gd name="connsiteX1" fmla="*/ 9196871 w 9196871"/>
              <a:gd name="connsiteY1" fmla="*/ 0 h 8235263"/>
              <a:gd name="connsiteX2" fmla="*/ 9196871 w 9196871"/>
              <a:gd name="connsiteY2" fmla="*/ 6858000 h 8235263"/>
              <a:gd name="connsiteX3" fmla="*/ 2955235 w 9196871"/>
              <a:gd name="connsiteY3" fmla="*/ 6884504 h 8235263"/>
              <a:gd name="connsiteX4" fmla="*/ 1868419 w 9196871"/>
              <a:gd name="connsiteY4" fmla="*/ 3498574 h 8235263"/>
              <a:gd name="connsiteX5" fmla="*/ 0 w 9196871"/>
              <a:gd name="connsiteY5" fmla="*/ 0 h 8235263"/>
              <a:gd name="connsiteX0" fmla="*/ 0 w 9196871"/>
              <a:gd name="connsiteY0" fmla="*/ 0 h 8235263"/>
              <a:gd name="connsiteX1" fmla="*/ 9196871 w 9196871"/>
              <a:gd name="connsiteY1" fmla="*/ 0 h 8235263"/>
              <a:gd name="connsiteX2" fmla="*/ 9196871 w 9196871"/>
              <a:gd name="connsiteY2" fmla="*/ 6858000 h 8235263"/>
              <a:gd name="connsiteX3" fmla="*/ 2955235 w 9196871"/>
              <a:gd name="connsiteY3" fmla="*/ 6884504 h 8235263"/>
              <a:gd name="connsiteX4" fmla="*/ 1868419 w 9196871"/>
              <a:gd name="connsiteY4" fmla="*/ 3498574 h 8235263"/>
              <a:gd name="connsiteX5" fmla="*/ 0 w 9196871"/>
              <a:gd name="connsiteY5" fmla="*/ 0 h 8235263"/>
              <a:gd name="connsiteX0" fmla="*/ 0 w 9196871"/>
              <a:gd name="connsiteY0" fmla="*/ 0 h 7375868"/>
              <a:gd name="connsiteX1" fmla="*/ 9196871 w 9196871"/>
              <a:gd name="connsiteY1" fmla="*/ 0 h 7375868"/>
              <a:gd name="connsiteX2" fmla="*/ 9196871 w 9196871"/>
              <a:gd name="connsiteY2" fmla="*/ 6858000 h 7375868"/>
              <a:gd name="connsiteX3" fmla="*/ 2955235 w 9196871"/>
              <a:gd name="connsiteY3" fmla="*/ 6884504 h 7375868"/>
              <a:gd name="connsiteX4" fmla="*/ 1868419 w 9196871"/>
              <a:gd name="connsiteY4" fmla="*/ 3498574 h 7375868"/>
              <a:gd name="connsiteX5" fmla="*/ 0 w 9196871"/>
              <a:gd name="connsiteY5" fmla="*/ 0 h 7375868"/>
              <a:gd name="connsiteX0" fmla="*/ 0 w 9196871"/>
              <a:gd name="connsiteY0" fmla="*/ 0 h 7135413"/>
              <a:gd name="connsiteX1" fmla="*/ 9196871 w 9196871"/>
              <a:gd name="connsiteY1" fmla="*/ 0 h 7135413"/>
              <a:gd name="connsiteX2" fmla="*/ 9196871 w 9196871"/>
              <a:gd name="connsiteY2" fmla="*/ 6858000 h 7135413"/>
              <a:gd name="connsiteX3" fmla="*/ 2955235 w 9196871"/>
              <a:gd name="connsiteY3" fmla="*/ 6884504 h 7135413"/>
              <a:gd name="connsiteX4" fmla="*/ 2464767 w 9196871"/>
              <a:gd name="connsiteY4" fmla="*/ 3405809 h 7135413"/>
              <a:gd name="connsiteX5" fmla="*/ 0 w 9196871"/>
              <a:gd name="connsiteY5" fmla="*/ 0 h 7135413"/>
              <a:gd name="connsiteX0" fmla="*/ 0 w 9196871"/>
              <a:gd name="connsiteY0" fmla="*/ 0 h 6884523"/>
              <a:gd name="connsiteX1" fmla="*/ 9196871 w 9196871"/>
              <a:gd name="connsiteY1" fmla="*/ 0 h 6884523"/>
              <a:gd name="connsiteX2" fmla="*/ 9196871 w 9196871"/>
              <a:gd name="connsiteY2" fmla="*/ 6858000 h 6884523"/>
              <a:gd name="connsiteX3" fmla="*/ 2955235 w 9196871"/>
              <a:gd name="connsiteY3" fmla="*/ 6884504 h 6884523"/>
              <a:gd name="connsiteX4" fmla="*/ 2464767 w 9196871"/>
              <a:gd name="connsiteY4" fmla="*/ 3405809 h 6884523"/>
              <a:gd name="connsiteX5" fmla="*/ 0 w 9196871"/>
              <a:gd name="connsiteY5" fmla="*/ 0 h 6884523"/>
              <a:gd name="connsiteX0" fmla="*/ 0 w 9196871"/>
              <a:gd name="connsiteY0" fmla="*/ 0 h 6884523"/>
              <a:gd name="connsiteX1" fmla="*/ 9196871 w 9196871"/>
              <a:gd name="connsiteY1" fmla="*/ 0 h 6884523"/>
              <a:gd name="connsiteX2" fmla="*/ 9196871 w 9196871"/>
              <a:gd name="connsiteY2" fmla="*/ 6858000 h 6884523"/>
              <a:gd name="connsiteX3" fmla="*/ 4505739 w 9196871"/>
              <a:gd name="connsiteY3" fmla="*/ 6884504 h 6884523"/>
              <a:gd name="connsiteX4" fmla="*/ 2464767 w 9196871"/>
              <a:gd name="connsiteY4" fmla="*/ 3405809 h 6884523"/>
              <a:gd name="connsiteX5" fmla="*/ 0 w 9196871"/>
              <a:gd name="connsiteY5" fmla="*/ 0 h 6884523"/>
              <a:gd name="connsiteX0" fmla="*/ 0 w 8216211"/>
              <a:gd name="connsiteY0" fmla="*/ 0 h 6937532"/>
              <a:gd name="connsiteX1" fmla="*/ 8216211 w 8216211"/>
              <a:gd name="connsiteY1" fmla="*/ 53009 h 6937532"/>
              <a:gd name="connsiteX2" fmla="*/ 8216211 w 8216211"/>
              <a:gd name="connsiteY2" fmla="*/ 6911009 h 6937532"/>
              <a:gd name="connsiteX3" fmla="*/ 3525079 w 8216211"/>
              <a:gd name="connsiteY3" fmla="*/ 6937513 h 6937532"/>
              <a:gd name="connsiteX4" fmla="*/ 1484107 w 8216211"/>
              <a:gd name="connsiteY4" fmla="*/ 3458818 h 6937532"/>
              <a:gd name="connsiteX5" fmla="*/ 0 w 8216211"/>
              <a:gd name="connsiteY5" fmla="*/ 0 h 6937532"/>
              <a:gd name="connsiteX0" fmla="*/ 0 w 9090854"/>
              <a:gd name="connsiteY0" fmla="*/ 0 h 6911028"/>
              <a:gd name="connsiteX1" fmla="*/ 9090854 w 9090854"/>
              <a:gd name="connsiteY1" fmla="*/ 26505 h 6911028"/>
              <a:gd name="connsiteX2" fmla="*/ 9090854 w 9090854"/>
              <a:gd name="connsiteY2" fmla="*/ 6884505 h 6911028"/>
              <a:gd name="connsiteX3" fmla="*/ 4399722 w 9090854"/>
              <a:gd name="connsiteY3" fmla="*/ 6911009 h 6911028"/>
              <a:gd name="connsiteX4" fmla="*/ 2358750 w 9090854"/>
              <a:gd name="connsiteY4" fmla="*/ 3432314 h 6911028"/>
              <a:gd name="connsiteX5" fmla="*/ 0 w 9090854"/>
              <a:gd name="connsiteY5" fmla="*/ 0 h 6911028"/>
              <a:gd name="connsiteX0" fmla="*/ 0 w 9090854"/>
              <a:gd name="connsiteY0" fmla="*/ 0 h 6911031"/>
              <a:gd name="connsiteX1" fmla="*/ 9090854 w 9090854"/>
              <a:gd name="connsiteY1" fmla="*/ 26505 h 6911031"/>
              <a:gd name="connsiteX2" fmla="*/ 9090854 w 9090854"/>
              <a:gd name="connsiteY2" fmla="*/ 6884505 h 6911031"/>
              <a:gd name="connsiteX3" fmla="*/ 4399722 w 9090854"/>
              <a:gd name="connsiteY3" fmla="*/ 6911009 h 6911031"/>
              <a:gd name="connsiteX4" fmla="*/ 2358750 w 9090854"/>
              <a:gd name="connsiteY4" fmla="*/ 3432314 h 6911031"/>
              <a:gd name="connsiteX5" fmla="*/ 0 w 9090854"/>
              <a:gd name="connsiteY5" fmla="*/ 0 h 6911031"/>
              <a:gd name="connsiteX0" fmla="*/ 0 w 9090854"/>
              <a:gd name="connsiteY0" fmla="*/ 0 h 7273795"/>
              <a:gd name="connsiteX1" fmla="*/ 9090854 w 9090854"/>
              <a:gd name="connsiteY1" fmla="*/ 26505 h 7273795"/>
              <a:gd name="connsiteX2" fmla="*/ 9090854 w 9090854"/>
              <a:gd name="connsiteY2" fmla="*/ 6884505 h 7273795"/>
              <a:gd name="connsiteX3" fmla="*/ 4399722 w 9090854"/>
              <a:gd name="connsiteY3" fmla="*/ 6911009 h 7273795"/>
              <a:gd name="connsiteX4" fmla="*/ 2358750 w 9090854"/>
              <a:gd name="connsiteY4" fmla="*/ 3432314 h 7273795"/>
              <a:gd name="connsiteX5" fmla="*/ 0 w 9090854"/>
              <a:gd name="connsiteY5" fmla="*/ 0 h 7273795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399722 w 9090854"/>
              <a:gd name="connsiteY3" fmla="*/ 6911009 h 6911009"/>
              <a:gd name="connsiteX4" fmla="*/ 2358750 w 9090854"/>
              <a:gd name="connsiteY4" fmla="*/ 3432314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399722 w 9090854"/>
              <a:gd name="connsiteY3" fmla="*/ 6911009 h 6911009"/>
              <a:gd name="connsiteX4" fmla="*/ 2358750 w 9090854"/>
              <a:gd name="connsiteY4" fmla="*/ 3432314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399722 w 9090854"/>
              <a:gd name="connsiteY3" fmla="*/ 6911009 h 6911009"/>
              <a:gd name="connsiteX4" fmla="*/ 2358750 w 9090854"/>
              <a:gd name="connsiteY4" fmla="*/ 3432314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505739 w 9090854"/>
              <a:gd name="connsiteY3" fmla="*/ 6911009 h 6911009"/>
              <a:gd name="connsiteX4" fmla="*/ 2358750 w 9090854"/>
              <a:gd name="connsiteY4" fmla="*/ 3432314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505739 w 9090854"/>
              <a:gd name="connsiteY3" fmla="*/ 6911009 h 6911009"/>
              <a:gd name="connsiteX4" fmla="*/ 2544281 w 9090854"/>
              <a:gd name="connsiteY4" fmla="*/ 3419062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505739 w 9090854"/>
              <a:gd name="connsiteY3" fmla="*/ 6911009 h 6911009"/>
              <a:gd name="connsiteX4" fmla="*/ 2544281 w 9090854"/>
              <a:gd name="connsiteY4" fmla="*/ 3419062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505739 w 9090854"/>
              <a:gd name="connsiteY3" fmla="*/ 6911009 h 6911009"/>
              <a:gd name="connsiteX4" fmla="*/ 2544281 w 9090854"/>
              <a:gd name="connsiteY4" fmla="*/ 3419062 h 6911009"/>
              <a:gd name="connsiteX5" fmla="*/ 0 w 9090854"/>
              <a:gd name="connsiteY5" fmla="*/ 0 h 6911009"/>
              <a:gd name="connsiteX0" fmla="*/ 0 w 9090854"/>
              <a:gd name="connsiteY0" fmla="*/ 0 h 6950766"/>
              <a:gd name="connsiteX1" fmla="*/ 9090854 w 9090854"/>
              <a:gd name="connsiteY1" fmla="*/ 26505 h 6950766"/>
              <a:gd name="connsiteX2" fmla="*/ 9090854 w 9090854"/>
              <a:gd name="connsiteY2" fmla="*/ 6884505 h 6950766"/>
              <a:gd name="connsiteX3" fmla="*/ 4373218 w 9090854"/>
              <a:gd name="connsiteY3" fmla="*/ 6950766 h 6950766"/>
              <a:gd name="connsiteX4" fmla="*/ 2544281 w 9090854"/>
              <a:gd name="connsiteY4" fmla="*/ 3419062 h 6950766"/>
              <a:gd name="connsiteX5" fmla="*/ 0 w 9090854"/>
              <a:gd name="connsiteY5" fmla="*/ 0 h 6950766"/>
              <a:gd name="connsiteX0" fmla="*/ 0 w 9090854"/>
              <a:gd name="connsiteY0" fmla="*/ 0 h 6950766"/>
              <a:gd name="connsiteX1" fmla="*/ 9090854 w 9090854"/>
              <a:gd name="connsiteY1" fmla="*/ 26505 h 6950766"/>
              <a:gd name="connsiteX2" fmla="*/ 9090854 w 9090854"/>
              <a:gd name="connsiteY2" fmla="*/ 6884505 h 6950766"/>
              <a:gd name="connsiteX3" fmla="*/ 4373218 w 9090854"/>
              <a:gd name="connsiteY3" fmla="*/ 6950766 h 6950766"/>
              <a:gd name="connsiteX4" fmla="*/ 2544281 w 9090854"/>
              <a:gd name="connsiteY4" fmla="*/ 3419062 h 6950766"/>
              <a:gd name="connsiteX5" fmla="*/ 0 w 9090854"/>
              <a:gd name="connsiteY5" fmla="*/ 0 h 6950766"/>
              <a:gd name="connsiteX0" fmla="*/ 0 w 9090854"/>
              <a:gd name="connsiteY0" fmla="*/ 0 h 6950766"/>
              <a:gd name="connsiteX1" fmla="*/ 9090854 w 9090854"/>
              <a:gd name="connsiteY1" fmla="*/ 26505 h 6950766"/>
              <a:gd name="connsiteX2" fmla="*/ 9090854 w 9090854"/>
              <a:gd name="connsiteY2" fmla="*/ 6884505 h 6950766"/>
              <a:gd name="connsiteX3" fmla="*/ 4373218 w 9090854"/>
              <a:gd name="connsiteY3" fmla="*/ 6950766 h 6950766"/>
              <a:gd name="connsiteX4" fmla="*/ 2544281 w 9090854"/>
              <a:gd name="connsiteY4" fmla="*/ 3419062 h 6950766"/>
              <a:gd name="connsiteX5" fmla="*/ 0 w 9090854"/>
              <a:gd name="connsiteY5" fmla="*/ 0 h 6950766"/>
              <a:gd name="connsiteX0" fmla="*/ 0 w 9090854"/>
              <a:gd name="connsiteY0" fmla="*/ 0 h 6950766"/>
              <a:gd name="connsiteX1" fmla="*/ 9090854 w 9090854"/>
              <a:gd name="connsiteY1" fmla="*/ 26505 h 6950766"/>
              <a:gd name="connsiteX2" fmla="*/ 9090854 w 9090854"/>
              <a:gd name="connsiteY2" fmla="*/ 6884505 h 6950766"/>
              <a:gd name="connsiteX3" fmla="*/ 4373218 w 9090854"/>
              <a:gd name="connsiteY3" fmla="*/ 6950766 h 6950766"/>
              <a:gd name="connsiteX4" fmla="*/ 2544281 w 9090854"/>
              <a:gd name="connsiteY4" fmla="*/ 3419062 h 6950766"/>
              <a:gd name="connsiteX5" fmla="*/ 0 w 9090854"/>
              <a:gd name="connsiteY5" fmla="*/ 0 h 69507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9090854" h="6950766">
                <a:moveTo>
                  <a:pt x="0" y="0"/>
                </a:moveTo>
                <a:lnTo>
                  <a:pt x="9090854" y="26505"/>
                </a:lnTo>
                <a:lnTo>
                  <a:pt x="9090854" y="6884505"/>
                </a:lnTo>
                <a:lnTo>
                  <a:pt x="4373218" y="6950766"/>
                </a:lnTo>
                <a:cubicBezTo>
                  <a:pt x="4072836" y="6083855"/>
                  <a:pt x="3434385" y="4977297"/>
                  <a:pt x="2544281" y="3419062"/>
                </a:cubicBezTo>
                <a:cubicBezTo>
                  <a:pt x="1375882" y="1662045"/>
                  <a:pt x="1110974" y="1470992"/>
                  <a:pt x="0" y="0"/>
                </a:cubicBezTo>
                <a:close/>
              </a:path>
            </a:pathLst>
          </a:custGeom>
          <a:pattFill prst="ltDnDiag">
            <a:fgClr>
              <a:schemeClr val="accent1"/>
            </a:fgClr>
            <a:bgClr>
              <a:schemeClr val="bg1"/>
            </a:bgClr>
          </a:pattFill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46576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70AE0C-5D8A-EE43-B1F8-C68487F794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347011"/>
            <a:ext cx="7206075" cy="989633"/>
          </a:xfrm>
        </p:spPr>
        <p:txBody>
          <a:bodyPr>
            <a:norm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+mn-lt"/>
                <a:ea typeface="+mj-ea"/>
                <a:cs typeface="Arial" panose="020B0604020202020204" pitchFamily="34" charset="0"/>
              </a:defRPr>
            </a:lvl1pPr>
          </a:lstStyle>
          <a:p>
            <a:pPr marL="0" lvl="0" algn="l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</a:pPr>
            <a:r>
              <a:rPr lang="en-US"/>
              <a:t>CLICK TO ADD TITLE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F3C4D20-15AF-F243-BE34-915B6290DCDE}"/>
              </a:ext>
            </a:extLst>
          </p:cNvPr>
          <p:cNvGrpSpPr/>
          <p:nvPr userDrawn="1"/>
        </p:nvGrpSpPr>
        <p:grpSpPr>
          <a:xfrm>
            <a:off x="271364" y="1147207"/>
            <a:ext cx="7539226" cy="757752"/>
            <a:chOff x="425669" y="782185"/>
            <a:chExt cx="11826237" cy="516649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18EDC2C-5983-E048-8427-8703799A512A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62E2070B-AC95-C841-A46A-9D8A1BDE3A01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Footer Placeholder 2">
            <a:extLst>
              <a:ext uri="{FF2B5EF4-FFF2-40B4-BE49-F238E27FC236}">
                <a16:creationId xmlns:a16="http://schemas.microsoft.com/office/drawing/2014/main" id="{B7C46D7F-970B-445B-86BE-1110F3046F27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14" name="Picture 13" descr="Logo&#10;&#10;Description automatically generated">
            <a:extLst>
              <a:ext uri="{FF2B5EF4-FFF2-40B4-BE49-F238E27FC236}">
                <a16:creationId xmlns:a16="http://schemas.microsoft.com/office/drawing/2014/main" id="{31D92037-6C68-45A9-8B88-11A79F97228B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5" name="Slide Number Placeholder 5">
            <a:extLst>
              <a:ext uri="{FF2B5EF4-FFF2-40B4-BE49-F238E27FC236}">
                <a16:creationId xmlns:a16="http://schemas.microsoft.com/office/drawing/2014/main" id="{5A5616F3-0069-46BB-BF6C-EF3E7E57A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04356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Custom Layou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13">
            <a:extLst>
              <a:ext uri="{FF2B5EF4-FFF2-40B4-BE49-F238E27FC236}">
                <a16:creationId xmlns:a16="http://schemas.microsoft.com/office/drawing/2014/main" id="{056203DA-80D4-9449-A0DF-EBC662B3B854}"/>
              </a:ext>
            </a:extLst>
          </p:cNvPr>
          <p:cNvSpPr/>
          <p:nvPr userDrawn="1"/>
        </p:nvSpPr>
        <p:spPr>
          <a:xfrm>
            <a:off x="-56413" y="-47347"/>
            <a:ext cx="5515897" cy="10177848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4000">
                <a:srgbClr val="00AC69"/>
              </a:gs>
              <a:gs pos="100000">
                <a:srgbClr val="00ACD9">
                  <a:shade val="100000"/>
                  <a:satMod val="115000"/>
                </a:srgbClr>
              </a:gs>
            </a:gsLst>
            <a:lin ang="2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2" name="Rectangle 13">
            <a:extLst>
              <a:ext uri="{FF2B5EF4-FFF2-40B4-BE49-F238E27FC236}">
                <a16:creationId xmlns:a16="http://schemas.microsoft.com/office/drawing/2014/main" id="{D3A68B16-900F-8B41-AD87-B9B09D6D5AE5}"/>
              </a:ext>
            </a:extLst>
          </p:cNvPr>
          <p:cNvSpPr/>
          <p:nvPr userDrawn="1"/>
        </p:nvSpPr>
        <p:spPr>
          <a:xfrm>
            <a:off x="-56413" y="-59724"/>
            <a:ext cx="5515897" cy="5279997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0">
                <a:srgbClr val="003348">
                  <a:alpha val="68971"/>
                </a:srgbClr>
              </a:gs>
              <a:gs pos="90000">
                <a:srgbClr val="003348">
                  <a:alpha val="0"/>
                </a:srgbClr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B1378F1-9C26-4E45-B14E-F2B9E3922703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217590" y="509621"/>
            <a:ext cx="2694820" cy="1653291"/>
          </a:xfrm>
          <a:prstGeom prst="rect">
            <a:avLst/>
          </a:prstGeom>
        </p:spPr>
      </p:pic>
      <p:sp>
        <p:nvSpPr>
          <p:cNvPr id="5" name="Freeform 4">
            <a:extLst>
              <a:ext uri="{FF2B5EF4-FFF2-40B4-BE49-F238E27FC236}">
                <a16:creationId xmlns:a16="http://schemas.microsoft.com/office/drawing/2014/main" id="{8B568D2B-3EA9-6B4E-9125-900BD23544E8}"/>
              </a:ext>
            </a:extLst>
          </p:cNvPr>
          <p:cNvSpPr/>
          <p:nvPr userDrawn="1"/>
        </p:nvSpPr>
        <p:spPr>
          <a:xfrm>
            <a:off x="2521891" y="-47345"/>
            <a:ext cx="5796790" cy="10173353"/>
          </a:xfrm>
          <a:custGeom>
            <a:avLst/>
            <a:gdLst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104811"/>
              <a:gd name="connsiteY0" fmla="*/ 0 h 6936377"/>
              <a:gd name="connsiteX1" fmla="*/ 4441371 w 9104811"/>
              <a:gd name="connsiteY1" fmla="*/ 6936377 h 6936377"/>
              <a:gd name="connsiteX2" fmla="*/ 9091748 w 9104811"/>
              <a:gd name="connsiteY2" fmla="*/ 6897189 h 6936377"/>
              <a:gd name="connsiteX3" fmla="*/ 9104811 w 9104811"/>
              <a:gd name="connsiteY3" fmla="*/ 39189 h 6936377"/>
              <a:gd name="connsiteX4" fmla="*/ 0 w 9104811"/>
              <a:gd name="connsiteY4" fmla="*/ 0 h 6936377"/>
              <a:gd name="connsiteX0" fmla="*/ 0 w 9093004"/>
              <a:gd name="connsiteY0" fmla="*/ 0 h 6936377"/>
              <a:gd name="connsiteX1" fmla="*/ 4441371 w 9093004"/>
              <a:gd name="connsiteY1" fmla="*/ 6936377 h 6936377"/>
              <a:gd name="connsiteX2" fmla="*/ 9091748 w 9093004"/>
              <a:gd name="connsiteY2" fmla="*/ 6897189 h 6936377"/>
              <a:gd name="connsiteX3" fmla="*/ 9091748 w 9093004"/>
              <a:gd name="connsiteY3" fmla="*/ 13063 h 6936377"/>
              <a:gd name="connsiteX4" fmla="*/ 0 w 9093004"/>
              <a:gd name="connsiteY4" fmla="*/ 0 h 69363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093004" h="6936377">
                <a:moveTo>
                  <a:pt x="0" y="0"/>
                </a:moveTo>
                <a:cubicBezTo>
                  <a:pt x="2486297" y="2747554"/>
                  <a:pt x="2804161" y="3705497"/>
                  <a:pt x="4441371" y="6936377"/>
                </a:cubicBezTo>
                <a:lnTo>
                  <a:pt x="9091748" y="6897189"/>
                </a:lnTo>
                <a:cubicBezTo>
                  <a:pt x="9096102" y="4611189"/>
                  <a:pt x="9087394" y="2299063"/>
                  <a:pt x="9091748" y="13063"/>
                </a:cubicBezTo>
                <a:lnTo>
                  <a:pt x="0" y="0"/>
                </a:lnTo>
                <a:close/>
              </a:path>
            </a:pathLst>
          </a:custGeom>
          <a:blipFill dpi="0" rotWithShape="1">
            <a:blip r:embed="rId3"/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837FBB0-1B61-0849-89A7-5F58A4CB3DD3}"/>
              </a:ext>
            </a:extLst>
          </p:cNvPr>
          <p:cNvPicPr>
            <a:picLocks noChangeAspect="1"/>
          </p:cNvPicPr>
          <p:nvPr userDrawn="1"/>
        </p:nvPicPr>
        <p:blipFill>
          <a:blip r:embed="rId4">
            <a:alphaModFix amt="50000"/>
          </a:blip>
          <a:srcRect/>
          <a:stretch/>
        </p:blipFill>
        <p:spPr>
          <a:xfrm>
            <a:off x="-1036238" y="1687219"/>
            <a:ext cx="5104212" cy="107134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075842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itle 3">
            <a:extLst>
              <a:ext uri="{FF2B5EF4-FFF2-40B4-BE49-F238E27FC236}">
                <a16:creationId xmlns:a16="http://schemas.microsoft.com/office/drawing/2014/main" id="{1665B9B6-2093-9348-B817-8C8141F9132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777240" y="1954243"/>
            <a:ext cx="5829300" cy="3879514"/>
          </a:xfrm>
        </p:spPr>
        <p:txBody>
          <a:bodyPr>
            <a:normAutofit/>
          </a:bodyPr>
          <a:lstStyle>
            <a:lvl1pPr algn="ctr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lang="en-US" sz="3825" b="1" i="0" kern="1200" dirty="0">
                <a:solidFill>
                  <a:schemeClr val="tx1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17" name="Subtitle 2">
            <a:extLst>
              <a:ext uri="{FF2B5EF4-FFF2-40B4-BE49-F238E27FC236}">
                <a16:creationId xmlns:a16="http://schemas.microsoft.com/office/drawing/2014/main" id="{A2035886-23D7-2640-9418-936D8A0FB224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781759" y="5150344"/>
            <a:ext cx="5829300" cy="2428451"/>
          </a:xfrm>
        </p:spPr>
        <p:txBody>
          <a:bodyPr/>
          <a:lstStyle>
            <a:lvl1pPr marL="0" indent="0" algn="ctr">
              <a:buNone/>
              <a:defRPr sz="153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ADD SUBTITLE</a:t>
            </a:r>
          </a:p>
        </p:txBody>
      </p:sp>
      <p:pic>
        <p:nvPicPr>
          <p:cNvPr id="14" name="Picture 13" descr="A picture containing outdoor object, silhouette&#10;&#10;Description automatically generated">
            <a:extLst>
              <a:ext uri="{FF2B5EF4-FFF2-40B4-BE49-F238E27FC236}">
                <a16:creationId xmlns:a16="http://schemas.microsoft.com/office/drawing/2014/main" id="{493E1481-65C0-A749-9C25-13CB5FFF4A5A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alphaModFix amt="20000"/>
          </a:blip>
          <a:stretch>
            <a:fillRect/>
          </a:stretch>
        </p:blipFill>
        <p:spPr>
          <a:xfrm>
            <a:off x="-1703970" y="-3407720"/>
            <a:ext cx="4661250" cy="10723922"/>
          </a:xfrm>
          <a:prstGeom prst="rect">
            <a:avLst/>
          </a:prstGeom>
        </p:spPr>
      </p:pic>
      <p:pic>
        <p:nvPicPr>
          <p:cNvPr id="10" name="Picture 9" descr="Logo&#10;&#10;Description automatically generated">
            <a:extLst>
              <a:ext uri="{FF2B5EF4-FFF2-40B4-BE49-F238E27FC236}">
                <a16:creationId xmlns:a16="http://schemas.microsoft.com/office/drawing/2014/main" id="{A20578C9-8682-CF43-B945-AE74D691C8D9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2DDD52D1-8EEB-BC48-84AB-B1E66DE13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81F8230-BA7D-E346-9C0B-4361254BD5C2}"/>
              </a:ext>
            </a:extLst>
          </p:cNvPr>
          <p:cNvGrpSpPr/>
          <p:nvPr userDrawn="1"/>
        </p:nvGrpSpPr>
        <p:grpSpPr>
          <a:xfrm>
            <a:off x="233175" y="4752033"/>
            <a:ext cx="7539226" cy="757752"/>
            <a:chOff x="425669" y="782185"/>
            <a:chExt cx="11826237" cy="516649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46C28DA0-8168-CF43-A0D6-CCB79BD071FB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F89CFA10-9333-F74E-948C-71F6E05F4301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4456136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EFCA15DF-8235-1B47-AC0B-DC7312362C71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-47593"/>
            <a:ext cx="7772400" cy="10105993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B76F8E48-EA0B-8A4F-A3DD-0EFBE429DE4A}"/>
              </a:ext>
            </a:extLst>
          </p:cNvPr>
          <p:cNvSpPr/>
          <p:nvPr userDrawn="1"/>
        </p:nvSpPr>
        <p:spPr>
          <a:xfrm>
            <a:off x="0" y="-44122"/>
            <a:ext cx="7772400" cy="10131551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100000">
                <a:schemeClr val="accent2">
                  <a:alpha val="22764"/>
                </a:schemeClr>
              </a:gs>
              <a:gs pos="0">
                <a:schemeClr val="accent1"/>
              </a:gs>
            </a:gsLst>
            <a:path path="circle">
              <a:fillToRect r="100000" b="100000"/>
            </a:path>
            <a:tileRect l="-100000" t="-10000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5" name="Title 3">
            <a:extLst>
              <a:ext uri="{FF2B5EF4-FFF2-40B4-BE49-F238E27FC236}">
                <a16:creationId xmlns:a16="http://schemas.microsoft.com/office/drawing/2014/main" id="{DC97204D-04AD-3C4E-BF9F-96669A09144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777240" y="2116351"/>
            <a:ext cx="5829300" cy="3879514"/>
          </a:xfrm>
        </p:spPr>
        <p:txBody>
          <a:bodyPr>
            <a:normAutofit/>
          </a:bodyPr>
          <a:lstStyle>
            <a:lvl1pPr algn="ctr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lang="en-US" sz="3825" b="1" i="0" kern="1200" dirty="0">
                <a:solidFill>
                  <a:schemeClr val="bg1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16" name="Subtitle 2">
            <a:extLst>
              <a:ext uri="{FF2B5EF4-FFF2-40B4-BE49-F238E27FC236}">
                <a16:creationId xmlns:a16="http://schemas.microsoft.com/office/drawing/2014/main" id="{D5C32A59-C433-4E42-850D-234C288DD91C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781759" y="5297714"/>
            <a:ext cx="5829300" cy="2428451"/>
          </a:xfrm>
        </p:spPr>
        <p:txBody>
          <a:bodyPr/>
          <a:lstStyle>
            <a:lvl1pPr marL="0" indent="0" algn="ctr">
              <a:buNone/>
              <a:defRPr sz="153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ADD SUBTITLE</a:t>
            </a:r>
          </a:p>
        </p:txBody>
      </p:sp>
      <p:pic>
        <p:nvPicPr>
          <p:cNvPr id="9" name="Picture 8" descr="Logo&#10;&#10;Description automatically generated">
            <a:extLst>
              <a:ext uri="{FF2B5EF4-FFF2-40B4-BE49-F238E27FC236}">
                <a16:creationId xmlns:a16="http://schemas.microsoft.com/office/drawing/2014/main" id="{ECA4B55E-3830-664E-A647-DA1D1B8C6BEA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757" y="9173263"/>
            <a:ext cx="869698" cy="785249"/>
          </a:xfrm>
          <a:prstGeom prst="rect">
            <a:avLst/>
          </a:prstGeom>
        </p:spPr>
      </p:pic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9A8E647E-3F42-4D9C-A56E-85DD3709E4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solidFill>
                  <a:schemeClr val="bg1"/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07180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_Title 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B76F8E48-EA0B-8A4F-A3DD-0EFBE429DE4A}"/>
              </a:ext>
            </a:extLst>
          </p:cNvPr>
          <p:cNvSpPr/>
          <p:nvPr userDrawn="1"/>
        </p:nvSpPr>
        <p:spPr>
          <a:xfrm>
            <a:off x="0" y="2"/>
            <a:ext cx="7772400" cy="10296887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100000">
                <a:srgbClr val="00AC69"/>
              </a:gs>
              <a:gs pos="0">
                <a:srgbClr val="00ACD9">
                  <a:shade val="100000"/>
                  <a:satMod val="115000"/>
                </a:srgbClr>
              </a:gs>
            </a:gsLst>
            <a:lin ang="27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5" name="Title 3">
            <a:extLst>
              <a:ext uri="{FF2B5EF4-FFF2-40B4-BE49-F238E27FC236}">
                <a16:creationId xmlns:a16="http://schemas.microsoft.com/office/drawing/2014/main" id="{DC97204D-04AD-3C4E-BF9F-96669A09144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777240" y="2116351"/>
            <a:ext cx="5829300" cy="3879514"/>
          </a:xfrm>
        </p:spPr>
        <p:txBody>
          <a:bodyPr>
            <a:normAutofit/>
          </a:bodyPr>
          <a:lstStyle>
            <a:lvl1pPr algn="ctr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lang="en-US" sz="3825" b="1" i="0" kern="1200" dirty="0">
                <a:solidFill>
                  <a:schemeClr val="bg1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16" name="Subtitle 2">
            <a:extLst>
              <a:ext uri="{FF2B5EF4-FFF2-40B4-BE49-F238E27FC236}">
                <a16:creationId xmlns:a16="http://schemas.microsoft.com/office/drawing/2014/main" id="{D5C32A59-C433-4E42-850D-234C288DD91C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781759" y="5297714"/>
            <a:ext cx="5829300" cy="2428451"/>
          </a:xfrm>
        </p:spPr>
        <p:txBody>
          <a:bodyPr/>
          <a:lstStyle>
            <a:lvl1pPr marL="0" indent="0" algn="ctr">
              <a:buNone/>
              <a:defRPr sz="153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ADD SUBTITLE</a:t>
            </a:r>
          </a:p>
        </p:txBody>
      </p:sp>
      <p:pic>
        <p:nvPicPr>
          <p:cNvPr id="8" name="Picture 7" descr="Logo&#10;&#10;Description automatically generated">
            <a:extLst>
              <a:ext uri="{FF2B5EF4-FFF2-40B4-BE49-F238E27FC236}">
                <a16:creationId xmlns:a16="http://schemas.microsoft.com/office/drawing/2014/main" id="{DEAEACF5-5A18-EA4F-B867-6C4F72696749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757" y="9173263"/>
            <a:ext cx="869698" cy="785249"/>
          </a:xfrm>
          <a:prstGeom prst="rect">
            <a:avLst/>
          </a:prstGeom>
        </p:spPr>
      </p:pic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F8D271CE-BBE9-4C55-8943-9EB4F29B1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solidFill>
                  <a:schemeClr val="bg1"/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37137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70AE0C-5D8A-EE43-B1F8-C68487F794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536450"/>
            <a:ext cx="7185973" cy="1944159"/>
          </a:xfrm>
        </p:spPr>
        <p:txBody>
          <a:bodyPr>
            <a:norm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pPr marL="0" lvl="0" algn="l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</a:pPr>
            <a:r>
              <a:rPr lang="en-US"/>
              <a:t>CLICK TO ADD TITLE</a:t>
            </a:r>
            <a:br>
              <a:rPr lang="en-US"/>
            </a:br>
            <a:r>
              <a:rPr lang="en-US"/>
              <a:t>(UP TO TWO ROWS)</a:t>
            </a:r>
          </a:p>
        </p:txBody>
      </p:sp>
      <p:sp>
        <p:nvSpPr>
          <p:cNvPr id="14" name="Text Placeholder 13">
            <a:extLst>
              <a:ext uri="{FF2B5EF4-FFF2-40B4-BE49-F238E27FC236}">
                <a16:creationId xmlns:a16="http://schemas.microsoft.com/office/drawing/2014/main" id="{8785F5E6-8451-954A-91C7-CF6D629CE1DC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07534" y="2463272"/>
            <a:ext cx="7178232" cy="726659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530" b="1">
                <a:latin typeface="+mn-lt"/>
                <a:cs typeface="Arial" panose="020B0604020202020204" pitchFamily="34" charset="0"/>
              </a:defRPr>
            </a:lvl1pPr>
          </a:lstStyle>
          <a:p>
            <a:pPr lvl="0"/>
            <a:r>
              <a:rPr lang="en-US"/>
              <a:t>CLICK TO ADD SUBTITLE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F845C9-7574-344F-A1F3-2989252A9CF5}"/>
              </a:ext>
            </a:extLst>
          </p:cNvPr>
          <p:cNvSpPr>
            <a:spLocks noGrp="1"/>
          </p:cNvSpPr>
          <p:nvPr>
            <p:ph sz="quarter" idx="15" hasCustomPrompt="1"/>
          </p:nvPr>
        </p:nvSpPr>
        <p:spPr>
          <a:xfrm>
            <a:off x="307534" y="3362114"/>
            <a:ext cx="7178232" cy="5005917"/>
          </a:xfrm>
        </p:spPr>
        <p:txBody>
          <a:bodyPr>
            <a:normAutofit/>
          </a:bodyPr>
          <a:lstStyle>
            <a:lvl1pPr>
              <a:buClr>
                <a:schemeClr val="accent3"/>
              </a:buClr>
              <a:buSzPct val="85000"/>
              <a:defRPr sz="1148">
                <a:latin typeface="+mn-lt"/>
              </a:defRPr>
            </a:lvl1pPr>
            <a:lvl2pPr>
              <a:buClr>
                <a:schemeClr val="accent3"/>
              </a:buClr>
              <a:buSzPct val="85000"/>
              <a:defRPr sz="1020">
                <a:latin typeface="+mn-lt"/>
              </a:defRPr>
            </a:lvl2pPr>
            <a:lvl3pPr>
              <a:buClr>
                <a:schemeClr val="accent3"/>
              </a:buClr>
              <a:buSzPct val="85000"/>
              <a:defRPr sz="893">
                <a:latin typeface="+mn-lt"/>
              </a:defRPr>
            </a:lvl3pPr>
            <a:lvl4pPr>
              <a:buClr>
                <a:schemeClr val="accent3"/>
              </a:buClr>
              <a:buSzPct val="85000"/>
              <a:defRPr sz="765">
                <a:latin typeface="+mn-lt"/>
              </a:defRPr>
            </a:lvl4pPr>
            <a:lvl5pPr>
              <a:buClr>
                <a:schemeClr val="accent3"/>
              </a:buClr>
              <a:buSzPct val="85000"/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746BE3D0-3E3B-484D-AE7C-5DB6DCC12E92}"/>
              </a:ext>
            </a:extLst>
          </p:cNvPr>
          <p:cNvGrpSpPr/>
          <p:nvPr userDrawn="1"/>
        </p:nvGrpSpPr>
        <p:grpSpPr>
          <a:xfrm>
            <a:off x="271364" y="2068848"/>
            <a:ext cx="7539226" cy="757752"/>
            <a:chOff x="425669" y="782185"/>
            <a:chExt cx="11826237" cy="516649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B7AFA02-B9DB-0047-BD0C-744049FA73D3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776FB7D8-D0AB-4542-8E58-0359D221C05E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Footer Placeholder 2">
            <a:extLst>
              <a:ext uri="{FF2B5EF4-FFF2-40B4-BE49-F238E27FC236}">
                <a16:creationId xmlns:a16="http://schemas.microsoft.com/office/drawing/2014/main" id="{30B8D877-9D8D-43D2-97F5-66FCE4F33406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12" name="Picture 11" descr="Logo&#10;&#10;Description automatically generated">
            <a:extLst>
              <a:ext uri="{FF2B5EF4-FFF2-40B4-BE49-F238E27FC236}">
                <a16:creationId xmlns:a16="http://schemas.microsoft.com/office/drawing/2014/main" id="{B15D141D-59DD-4DCD-A4C7-464F3E93F8CE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5" name="Slide Number Placeholder 5">
            <a:extLst>
              <a:ext uri="{FF2B5EF4-FFF2-40B4-BE49-F238E27FC236}">
                <a16:creationId xmlns:a16="http://schemas.microsoft.com/office/drawing/2014/main" id="{F22004EF-FD5F-4018-BB7B-012732D84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290711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 descr="A picture containing outdoor object, silhouette&#10;&#10;Description automatically generated">
            <a:extLst>
              <a:ext uri="{FF2B5EF4-FFF2-40B4-BE49-F238E27FC236}">
                <a16:creationId xmlns:a16="http://schemas.microsoft.com/office/drawing/2014/main" id="{9B788A80-80A8-4AC9-9AC9-051AA0A10A96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print">
            <a:alphaModFix amt="2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2394" t="40680" r="33057" b="24884"/>
          <a:stretch/>
        </p:blipFill>
        <p:spPr>
          <a:xfrm rot="1799300">
            <a:off x="6239370" y="-414147"/>
            <a:ext cx="2076582" cy="369291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4170AE0C-5D8A-EE43-B1F8-C68487F794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89076" y="536450"/>
            <a:ext cx="7238377" cy="1944159"/>
          </a:xfrm>
        </p:spPr>
        <p:txBody>
          <a:bodyPr>
            <a:norm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pPr marL="0" lvl="0" algn="l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</a:pPr>
            <a:r>
              <a:rPr lang="en-US"/>
              <a:t>CLICK TO ADD TITLE</a:t>
            </a:r>
            <a:br>
              <a:rPr lang="en-US"/>
            </a:br>
            <a:r>
              <a:rPr lang="en-US"/>
              <a:t>(UP TO TWO ROWS)</a:t>
            </a:r>
          </a:p>
        </p:txBody>
      </p:sp>
      <p:sp>
        <p:nvSpPr>
          <p:cNvPr id="14" name="Text Placeholder 13">
            <a:extLst>
              <a:ext uri="{FF2B5EF4-FFF2-40B4-BE49-F238E27FC236}">
                <a16:creationId xmlns:a16="http://schemas.microsoft.com/office/drawing/2014/main" id="{8785F5E6-8451-954A-91C7-CF6D629CE1DC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289075" y="2501736"/>
            <a:ext cx="3477619" cy="726659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530" b="1">
                <a:latin typeface="+mn-lt"/>
                <a:cs typeface="Arial" panose="020B0604020202020204" pitchFamily="34" charset="0"/>
              </a:defRPr>
            </a:lvl1pPr>
          </a:lstStyle>
          <a:p>
            <a:pPr lvl="0"/>
            <a:r>
              <a:rPr lang="en-US"/>
              <a:t>CLICK TO ADD SUBTITLE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F845C9-7574-344F-A1F3-2989252A9CF5}"/>
              </a:ext>
            </a:extLst>
          </p:cNvPr>
          <p:cNvSpPr>
            <a:spLocks noGrp="1"/>
          </p:cNvSpPr>
          <p:nvPr>
            <p:ph sz="quarter" idx="15" hasCustomPrompt="1"/>
          </p:nvPr>
        </p:nvSpPr>
        <p:spPr>
          <a:xfrm>
            <a:off x="289075" y="3379092"/>
            <a:ext cx="3477619" cy="5005917"/>
          </a:xfrm>
        </p:spPr>
        <p:txBody>
          <a:bodyPr>
            <a:normAutofit/>
          </a:bodyPr>
          <a:lstStyle>
            <a:lvl1pPr>
              <a:buClr>
                <a:schemeClr val="accent3"/>
              </a:buClr>
              <a:buSzPct val="85000"/>
              <a:defRPr sz="1148">
                <a:latin typeface="+mn-lt"/>
              </a:defRPr>
            </a:lvl1pPr>
            <a:lvl2pPr>
              <a:buClr>
                <a:schemeClr val="accent3"/>
              </a:buClr>
              <a:buSzPct val="85000"/>
              <a:defRPr sz="1020">
                <a:latin typeface="+mn-lt"/>
              </a:defRPr>
            </a:lvl2pPr>
            <a:lvl3pPr>
              <a:buClr>
                <a:schemeClr val="accent3"/>
              </a:buClr>
              <a:buSzPct val="85000"/>
              <a:defRPr sz="893">
                <a:latin typeface="+mn-lt"/>
              </a:defRPr>
            </a:lvl3pPr>
            <a:lvl4pPr>
              <a:buClr>
                <a:schemeClr val="accent3"/>
              </a:buClr>
              <a:buSzPct val="85000"/>
              <a:defRPr sz="765">
                <a:latin typeface="+mn-lt"/>
              </a:defRPr>
            </a:lvl4pPr>
            <a:lvl5pPr>
              <a:buClr>
                <a:schemeClr val="accent3"/>
              </a:buClr>
              <a:buSzPct val="85000"/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3" name="Content Placeholder 3">
            <a:extLst>
              <a:ext uri="{FF2B5EF4-FFF2-40B4-BE49-F238E27FC236}">
                <a16:creationId xmlns:a16="http://schemas.microsoft.com/office/drawing/2014/main" id="{5B6091FA-36E4-CB45-AD7A-040BD568DEDC}"/>
              </a:ext>
            </a:extLst>
          </p:cNvPr>
          <p:cNvSpPr>
            <a:spLocks noGrp="1"/>
          </p:cNvSpPr>
          <p:nvPr>
            <p:ph sz="quarter" idx="16" hasCustomPrompt="1"/>
          </p:nvPr>
        </p:nvSpPr>
        <p:spPr>
          <a:xfrm>
            <a:off x="4049832" y="3362114"/>
            <a:ext cx="3477620" cy="5005917"/>
          </a:xfrm>
        </p:spPr>
        <p:txBody>
          <a:bodyPr>
            <a:normAutofit/>
          </a:bodyPr>
          <a:lstStyle>
            <a:lvl1pPr>
              <a:buClr>
                <a:schemeClr val="accent3"/>
              </a:buClr>
              <a:buSzPct val="85000"/>
              <a:defRPr sz="1148">
                <a:latin typeface="+mn-lt"/>
              </a:defRPr>
            </a:lvl1pPr>
            <a:lvl2pPr>
              <a:buClr>
                <a:schemeClr val="accent3"/>
              </a:buClr>
              <a:buSzPct val="85000"/>
              <a:defRPr sz="1020">
                <a:latin typeface="+mn-lt"/>
              </a:defRPr>
            </a:lvl2pPr>
            <a:lvl3pPr>
              <a:buClr>
                <a:schemeClr val="accent3"/>
              </a:buClr>
              <a:buSzPct val="85000"/>
              <a:defRPr sz="893">
                <a:latin typeface="+mn-lt"/>
              </a:defRPr>
            </a:lvl3pPr>
            <a:lvl4pPr>
              <a:buClr>
                <a:schemeClr val="accent3"/>
              </a:buClr>
              <a:buSzPct val="85000"/>
              <a:defRPr sz="765">
                <a:latin typeface="+mn-lt"/>
              </a:defRPr>
            </a:lvl4pPr>
            <a:lvl5pPr>
              <a:buClr>
                <a:schemeClr val="accent3"/>
              </a:buClr>
              <a:buSzPct val="85000"/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6" name="Text Placeholder 13">
            <a:extLst>
              <a:ext uri="{FF2B5EF4-FFF2-40B4-BE49-F238E27FC236}">
                <a16:creationId xmlns:a16="http://schemas.microsoft.com/office/drawing/2014/main" id="{E99F283D-55A7-8148-9946-FA086E5EB543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4049832" y="2487219"/>
            <a:ext cx="3477620" cy="726659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530" b="1">
                <a:latin typeface="+mn-lt"/>
                <a:cs typeface="Arial" panose="020B0604020202020204" pitchFamily="34" charset="0"/>
              </a:defRPr>
            </a:lvl1pPr>
          </a:lstStyle>
          <a:p>
            <a:pPr lvl="0"/>
            <a:r>
              <a:rPr lang="en-US"/>
              <a:t>CLICK TO ADD SUBTITLE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2352B31-B73E-044C-AD6A-3A630100A157}"/>
              </a:ext>
            </a:extLst>
          </p:cNvPr>
          <p:cNvGrpSpPr/>
          <p:nvPr userDrawn="1"/>
        </p:nvGrpSpPr>
        <p:grpSpPr>
          <a:xfrm>
            <a:off x="271364" y="2103424"/>
            <a:ext cx="7539226" cy="757752"/>
            <a:chOff x="425669" y="782185"/>
            <a:chExt cx="11826237" cy="516649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8B2453FB-A407-DE41-9C78-7140DBF4C31C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EC272CF5-8E28-A042-A3A4-4CF830698A7C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Footer Placeholder 2">
            <a:extLst>
              <a:ext uri="{FF2B5EF4-FFF2-40B4-BE49-F238E27FC236}">
                <a16:creationId xmlns:a16="http://schemas.microsoft.com/office/drawing/2014/main" id="{915258EC-E426-4A6C-A7FA-0D34466F0404}"/>
              </a:ext>
            </a:extLst>
          </p:cNvPr>
          <p:cNvSpPr>
            <a:spLocks noGrp="1"/>
          </p:cNvSpPr>
          <p:nvPr>
            <p:ph type="ftr" sz="quarter" idx="18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22" name="Picture 21" descr="Logo&#10;&#10;Description automatically generated">
            <a:extLst>
              <a:ext uri="{FF2B5EF4-FFF2-40B4-BE49-F238E27FC236}">
                <a16:creationId xmlns:a16="http://schemas.microsoft.com/office/drawing/2014/main" id="{AD129D8F-3430-4E45-A27D-7BDA6E7E765F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23" name="Slide Number Placeholder 5">
            <a:extLst>
              <a:ext uri="{FF2B5EF4-FFF2-40B4-BE49-F238E27FC236}">
                <a16:creationId xmlns:a16="http://schemas.microsoft.com/office/drawing/2014/main" id="{B8A3573C-CCFF-44F7-97B6-7967CBD08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552382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740641"/>
      </p:ext>
    </p:extLst>
  </p:cSld>
  <p:clrMapOvr>
    <a:masterClrMapping/>
  </p:clrMapOvr>
  <p:hf hdr="0" dt="0"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picture containing outdoor object, silhouette&#10;&#10;Description automatically generated">
            <a:extLst>
              <a:ext uri="{FF2B5EF4-FFF2-40B4-BE49-F238E27FC236}">
                <a16:creationId xmlns:a16="http://schemas.microsoft.com/office/drawing/2014/main" id="{98F8FA52-BDFF-407C-AD8A-E1A2357F63AD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print">
            <a:alphaModFix amt="2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2394" t="40680" r="33057" b="24884"/>
          <a:stretch/>
        </p:blipFill>
        <p:spPr>
          <a:xfrm rot="1799300">
            <a:off x="6239370" y="-414147"/>
            <a:ext cx="2076582" cy="3692913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7F3C4D20-15AF-F243-BE34-915B6290DCDE}"/>
              </a:ext>
            </a:extLst>
          </p:cNvPr>
          <p:cNvGrpSpPr/>
          <p:nvPr userDrawn="1"/>
        </p:nvGrpSpPr>
        <p:grpSpPr>
          <a:xfrm>
            <a:off x="271364" y="1147207"/>
            <a:ext cx="7539226" cy="757752"/>
            <a:chOff x="425669" y="782185"/>
            <a:chExt cx="11826237" cy="516649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18EDC2C-5983-E048-8427-8703799A512A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62E2070B-AC95-C841-A46A-9D8A1BDE3A01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Footer Placeholder 2">
            <a:extLst>
              <a:ext uri="{FF2B5EF4-FFF2-40B4-BE49-F238E27FC236}">
                <a16:creationId xmlns:a16="http://schemas.microsoft.com/office/drawing/2014/main" id="{B7C46D7F-970B-445B-86BE-1110F3046F27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14" name="Picture 13" descr="Logo&#10;&#10;Description automatically generated">
            <a:extLst>
              <a:ext uri="{FF2B5EF4-FFF2-40B4-BE49-F238E27FC236}">
                <a16:creationId xmlns:a16="http://schemas.microsoft.com/office/drawing/2014/main" id="{31D92037-6C68-45A9-8B88-11A79F97228B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5" name="Slide Number Placeholder 5">
            <a:extLst>
              <a:ext uri="{FF2B5EF4-FFF2-40B4-BE49-F238E27FC236}">
                <a16:creationId xmlns:a16="http://schemas.microsoft.com/office/drawing/2014/main" id="{5A5616F3-0069-46BB-BF6C-EF3E7E57A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F75FB8CE-1B8A-4AB7-929D-D9EF99C1217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347011"/>
            <a:ext cx="7206075" cy="989633"/>
          </a:xfrm>
        </p:spPr>
        <p:txBody>
          <a:bodyPr>
            <a:norm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+mn-lt"/>
                <a:ea typeface="+mj-ea"/>
                <a:cs typeface="Arial" panose="020B0604020202020204" pitchFamily="34" charset="0"/>
              </a:defRPr>
            </a:lvl1pPr>
          </a:lstStyle>
          <a:p>
            <a:pPr marL="0" lvl="0" algn="l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</a:pPr>
            <a:r>
              <a:rPr lang="en-US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44087115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vider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9754A5-CE6B-9048-86E9-32C2124FF354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535519"/>
            <a:ext cx="3310113" cy="1944159"/>
          </a:xfrm>
        </p:spPr>
        <p:txBody>
          <a:bodyPr>
            <a:no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  <a:br>
              <a:rPr lang="en-US"/>
            </a:br>
            <a:r>
              <a:rPr lang="en-US"/>
              <a:t>(UP TO TWO ROWS)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F2BB4F27-6068-4D4A-B6CE-5AE26E18D55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291466" y="2728807"/>
            <a:ext cx="3310113" cy="716484"/>
          </a:xfrm>
        </p:spPr>
        <p:txBody>
          <a:bodyPr>
            <a:normAutofit/>
          </a:bodyPr>
          <a:lstStyle>
            <a:lvl1pPr marL="0" indent="0">
              <a:buFontTx/>
              <a:buNone/>
              <a:defRPr lang="en-US" sz="1530" kern="1200" dirty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lvl1pPr>
          </a:lstStyle>
          <a:p>
            <a:pPr marL="0" lvl="0" indent="0" algn="l" defTabSz="582930" rtl="0" eaLnBrk="1" latinLnBrk="0" hangingPunct="1">
              <a:lnSpc>
                <a:spcPct val="90000"/>
              </a:lnSpc>
              <a:spcBef>
                <a:spcPts val="638"/>
              </a:spcBef>
              <a:buFontTx/>
              <a:buNone/>
            </a:pPr>
            <a:r>
              <a:rPr lang="en-US"/>
              <a:t>CLICK TO ADD SUBTITLE</a:t>
            </a:r>
          </a:p>
        </p:txBody>
      </p:sp>
      <p:sp>
        <p:nvSpPr>
          <p:cNvPr id="13" name="Content Placeholder 12">
            <a:extLst>
              <a:ext uri="{FF2B5EF4-FFF2-40B4-BE49-F238E27FC236}">
                <a16:creationId xmlns:a16="http://schemas.microsoft.com/office/drawing/2014/main" id="{63BCC444-F476-A64E-A9C2-9D68A9E90367}"/>
              </a:ext>
            </a:extLst>
          </p:cNvPr>
          <p:cNvSpPr>
            <a:spLocks noGrp="1"/>
          </p:cNvSpPr>
          <p:nvPr>
            <p:ph sz="quarter" idx="15" hasCustomPrompt="1"/>
          </p:nvPr>
        </p:nvSpPr>
        <p:spPr>
          <a:xfrm>
            <a:off x="291465" y="3615904"/>
            <a:ext cx="3313149" cy="4670637"/>
          </a:xfrm>
        </p:spPr>
        <p:txBody>
          <a:bodyPr>
            <a:normAutofit/>
          </a:bodyPr>
          <a:lstStyle>
            <a:lvl1pPr>
              <a:defRPr sz="1148">
                <a:latin typeface="+mn-lt"/>
              </a:defRPr>
            </a:lvl1pPr>
            <a:lvl2pPr>
              <a:defRPr sz="1020">
                <a:latin typeface="+mn-lt"/>
              </a:defRPr>
            </a:lvl2pPr>
            <a:lvl3pPr>
              <a:defRPr sz="893">
                <a:latin typeface="+mn-lt"/>
              </a:defRPr>
            </a:lvl3pPr>
            <a:lvl4pPr>
              <a:defRPr sz="765">
                <a:latin typeface="+mn-lt"/>
              </a:defRPr>
            </a:lvl4pPr>
            <a:lvl5pPr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1" name="Footer Placeholder 2">
            <a:extLst>
              <a:ext uri="{FF2B5EF4-FFF2-40B4-BE49-F238E27FC236}">
                <a16:creationId xmlns:a16="http://schemas.microsoft.com/office/drawing/2014/main" id="{76DAFEF3-E76F-4ACA-80D4-87E06E5BE4C2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12" name="Picture 11" descr="Logo&#10;&#10;Description automatically generated">
            <a:extLst>
              <a:ext uri="{FF2B5EF4-FFF2-40B4-BE49-F238E27FC236}">
                <a16:creationId xmlns:a16="http://schemas.microsoft.com/office/drawing/2014/main" id="{44A7FDB9-EB84-466E-B6C9-898305FFC4F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4" name="Slide Number Placeholder 5">
            <a:extLst>
              <a:ext uri="{FF2B5EF4-FFF2-40B4-BE49-F238E27FC236}">
                <a16:creationId xmlns:a16="http://schemas.microsoft.com/office/drawing/2014/main" id="{999D0610-7516-4B16-A716-2B58FCC0F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84237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68" userDrawn="1">
          <p15:clr>
            <a:srgbClr val="FBAE40"/>
          </p15:clr>
        </p15:guide>
        <p15:guide id="2" pos="275" userDrawn="1">
          <p15:clr>
            <a:srgbClr val="FBAE40"/>
          </p15:clr>
        </p15:guide>
      </p15:sldGuideLst>
    </p:ext>
  </p:extLs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Divider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Freeform 11">
            <a:extLst>
              <a:ext uri="{FF2B5EF4-FFF2-40B4-BE49-F238E27FC236}">
                <a16:creationId xmlns:a16="http://schemas.microsoft.com/office/drawing/2014/main" id="{4D89D5FE-94D8-2543-9E7D-A7EF8680F81A}"/>
              </a:ext>
            </a:extLst>
          </p:cNvPr>
          <p:cNvSpPr/>
          <p:nvPr userDrawn="1"/>
        </p:nvSpPr>
        <p:spPr>
          <a:xfrm>
            <a:off x="3545094" y="-91006"/>
            <a:ext cx="5796790" cy="10173353"/>
          </a:xfrm>
          <a:custGeom>
            <a:avLst/>
            <a:gdLst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104811"/>
              <a:gd name="connsiteY0" fmla="*/ 0 h 6936377"/>
              <a:gd name="connsiteX1" fmla="*/ 4441371 w 9104811"/>
              <a:gd name="connsiteY1" fmla="*/ 6936377 h 6936377"/>
              <a:gd name="connsiteX2" fmla="*/ 9091748 w 9104811"/>
              <a:gd name="connsiteY2" fmla="*/ 6897189 h 6936377"/>
              <a:gd name="connsiteX3" fmla="*/ 9104811 w 9104811"/>
              <a:gd name="connsiteY3" fmla="*/ 39189 h 6936377"/>
              <a:gd name="connsiteX4" fmla="*/ 0 w 9104811"/>
              <a:gd name="connsiteY4" fmla="*/ 0 h 6936377"/>
              <a:gd name="connsiteX0" fmla="*/ 0 w 9093004"/>
              <a:gd name="connsiteY0" fmla="*/ 0 h 6936377"/>
              <a:gd name="connsiteX1" fmla="*/ 4441371 w 9093004"/>
              <a:gd name="connsiteY1" fmla="*/ 6936377 h 6936377"/>
              <a:gd name="connsiteX2" fmla="*/ 9091748 w 9093004"/>
              <a:gd name="connsiteY2" fmla="*/ 6897189 h 6936377"/>
              <a:gd name="connsiteX3" fmla="*/ 9091748 w 9093004"/>
              <a:gd name="connsiteY3" fmla="*/ 13063 h 6936377"/>
              <a:gd name="connsiteX4" fmla="*/ 0 w 9093004"/>
              <a:gd name="connsiteY4" fmla="*/ 0 h 69363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093004" h="6936377">
                <a:moveTo>
                  <a:pt x="0" y="0"/>
                </a:moveTo>
                <a:cubicBezTo>
                  <a:pt x="2486297" y="2747554"/>
                  <a:pt x="2804161" y="3705497"/>
                  <a:pt x="4441371" y="6936377"/>
                </a:cubicBezTo>
                <a:lnTo>
                  <a:pt x="9091748" y="6897189"/>
                </a:lnTo>
                <a:cubicBezTo>
                  <a:pt x="9096102" y="4611189"/>
                  <a:pt x="9087394" y="2299063"/>
                  <a:pt x="9091748" y="13063"/>
                </a:cubicBezTo>
                <a:lnTo>
                  <a:pt x="0" y="0"/>
                </a:lnTo>
                <a:close/>
              </a:path>
            </a:pathLst>
          </a:cu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089754A5-CE6B-9048-86E9-32C2124FF354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535519"/>
            <a:ext cx="4346993" cy="1944159"/>
          </a:xfrm>
        </p:spPr>
        <p:txBody>
          <a:bodyPr>
            <a:no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  <a:br>
              <a:rPr lang="en-US"/>
            </a:br>
            <a:r>
              <a:rPr lang="en-US"/>
              <a:t>(UP TO TWO ROWS)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F2BB4F27-6068-4D4A-B6CE-5AE26E18D55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291465" y="2728807"/>
            <a:ext cx="4346994" cy="716484"/>
          </a:xfrm>
        </p:spPr>
        <p:txBody>
          <a:bodyPr>
            <a:normAutofit/>
          </a:bodyPr>
          <a:lstStyle>
            <a:lvl1pPr marL="0" indent="0">
              <a:buFontTx/>
              <a:buNone/>
              <a:defRPr lang="en-US" sz="1530" kern="1200" dirty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lvl1pPr>
          </a:lstStyle>
          <a:p>
            <a:pPr marL="0" lvl="0" indent="0" algn="l" defTabSz="582930" rtl="0" eaLnBrk="1" latinLnBrk="0" hangingPunct="1">
              <a:lnSpc>
                <a:spcPct val="90000"/>
              </a:lnSpc>
              <a:spcBef>
                <a:spcPts val="638"/>
              </a:spcBef>
              <a:buFontTx/>
              <a:buNone/>
            </a:pPr>
            <a:r>
              <a:rPr lang="en-US"/>
              <a:t>CLICK TO ADD SUBTITLE</a:t>
            </a:r>
          </a:p>
        </p:txBody>
      </p:sp>
      <p:sp>
        <p:nvSpPr>
          <p:cNvPr id="13" name="Content Placeholder 12">
            <a:extLst>
              <a:ext uri="{FF2B5EF4-FFF2-40B4-BE49-F238E27FC236}">
                <a16:creationId xmlns:a16="http://schemas.microsoft.com/office/drawing/2014/main" id="{63BCC444-F476-A64E-A9C2-9D68A9E90367}"/>
              </a:ext>
            </a:extLst>
          </p:cNvPr>
          <p:cNvSpPr>
            <a:spLocks noGrp="1"/>
          </p:cNvSpPr>
          <p:nvPr>
            <p:ph sz="quarter" idx="15" hasCustomPrompt="1"/>
          </p:nvPr>
        </p:nvSpPr>
        <p:spPr>
          <a:xfrm>
            <a:off x="291465" y="3615904"/>
            <a:ext cx="4651895" cy="4670637"/>
          </a:xfrm>
        </p:spPr>
        <p:txBody>
          <a:bodyPr>
            <a:normAutofit/>
          </a:bodyPr>
          <a:lstStyle>
            <a:lvl1pPr>
              <a:buClr>
                <a:srgbClr val="FF9014"/>
              </a:buClr>
              <a:defRPr sz="1148">
                <a:latin typeface="+mn-lt"/>
              </a:defRPr>
            </a:lvl1pPr>
            <a:lvl2pPr>
              <a:buClr>
                <a:srgbClr val="FF9014"/>
              </a:buClr>
              <a:defRPr sz="1020">
                <a:latin typeface="+mn-lt"/>
              </a:defRPr>
            </a:lvl2pPr>
            <a:lvl3pPr>
              <a:buClr>
                <a:srgbClr val="FF9014"/>
              </a:buClr>
              <a:defRPr sz="893">
                <a:latin typeface="+mn-lt"/>
              </a:defRPr>
            </a:lvl3pPr>
            <a:lvl4pPr>
              <a:buClr>
                <a:srgbClr val="FF9014"/>
              </a:buClr>
              <a:defRPr sz="765">
                <a:latin typeface="+mn-lt"/>
              </a:defRPr>
            </a:lvl4pPr>
            <a:lvl5pPr>
              <a:buClr>
                <a:srgbClr val="FF9014"/>
              </a:buClr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pic>
        <p:nvPicPr>
          <p:cNvPr id="10" name="Picture 9" descr="Logo&#10;&#10;Description automatically generated">
            <a:extLst>
              <a:ext uri="{FF2B5EF4-FFF2-40B4-BE49-F238E27FC236}">
                <a16:creationId xmlns:a16="http://schemas.microsoft.com/office/drawing/2014/main" id="{1883C8D4-A6A5-4934-BE27-62CBA0D3B9B5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701F2D71-5AEE-4112-AF0D-76620E9A8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solidFill>
                  <a:schemeClr val="bg1"/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22214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Custom Layou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8FB84A-568E-3D4A-8E78-BFC2709C292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535519"/>
            <a:ext cx="7206126" cy="1944159"/>
          </a:xfrm>
        </p:spPr>
        <p:txBody>
          <a:bodyPr lIns="91440">
            <a:no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6" name="Footer Placeholder 2">
            <a:extLst>
              <a:ext uri="{FF2B5EF4-FFF2-40B4-BE49-F238E27FC236}">
                <a16:creationId xmlns:a16="http://schemas.microsoft.com/office/drawing/2014/main" id="{131A987E-5441-4D1C-A1A3-8C6D8F45D064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7" name="Picture 6" descr="Logo&#10;&#10;Description automatically generated">
            <a:extLst>
              <a:ext uri="{FF2B5EF4-FFF2-40B4-BE49-F238E27FC236}">
                <a16:creationId xmlns:a16="http://schemas.microsoft.com/office/drawing/2014/main" id="{B8628AF9-2805-4A7A-A708-428FE5177A9D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D897C745-3944-4C2A-8D38-6C7D8E5E7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964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045047"/>
      </p:ext>
    </p:extLst>
  </p:cSld>
  <p:clrMapOvr>
    <a:masterClrMapping/>
  </p:clrMapOvr>
  <p:hf hd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145051"/>
      </p:ext>
    </p:extLst>
  </p:cSld>
  <p:clrMapOvr>
    <a:masterClrMapping/>
  </p:clrMapOvr>
  <p:hf hd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868843"/>
      </p:ext>
    </p:extLst>
  </p:cSld>
  <p:clrMapOvr>
    <a:masterClrMapping/>
  </p:clrMapOvr>
  <p:hf hd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756420"/>
      </p:ext>
    </p:extLst>
  </p:cSld>
  <p:clrMapOvr>
    <a:masterClrMapping/>
  </p:clrMapOvr>
  <p:hf hd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35578"/>
      </p:ext>
    </p:extLst>
  </p:cSld>
  <p:clrMapOvr>
    <a:masterClrMapping/>
  </p:clrMapOvr>
  <p:hf hd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809270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672831"/>
      </p:ext>
    </p:extLst>
  </p:cSld>
  <p:clrMapOvr>
    <a:masterClrMapping/>
  </p:clrMapOvr>
  <p:hf hd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569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3" r:id="rId1"/>
    <p:sldLayoutId id="2147483704" r:id="rId2"/>
    <p:sldLayoutId id="2147483705" r:id="rId3"/>
    <p:sldLayoutId id="2147483706" r:id="rId4"/>
    <p:sldLayoutId id="2147483707" r:id="rId5"/>
    <p:sldLayoutId id="2147483708" r:id="rId6"/>
    <p:sldLayoutId id="2147483709" r:id="rId7"/>
    <p:sldLayoutId id="2147483710" r:id="rId8"/>
    <p:sldLayoutId id="2147483711" r:id="rId9"/>
    <p:sldLayoutId id="2147483712" r:id="rId10"/>
    <p:sldLayoutId id="2147483713" r:id="rId11"/>
    <p:sldLayoutId id="2147483714" r:id="rId12"/>
    <p:sldLayoutId id="2147483715" r:id="rId13"/>
    <p:sldLayoutId id="2147483675" r:id="rId14"/>
    <p:sldLayoutId id="2147483671" r:id="rId15"/>
    <p:sldLayoutId id="2147483673" r:id="rId16"/>
    <p:sldLayoutId id="2147483681" r:id="rId17"/>
    <p:sldLayoutId id="2147483670" r:id="rId18"/>
    <p:sldLayoutId id="2147483676" r:id="rId19"/>
    <p:sldLayoutId id="2147483686" r:id="rId20"/>
    <p:sldLayoutId id="2147483652" r:id="rId21"/>
    <p:sldLayoutId id="2147483674" r:id="rId22"/>
    <p:sldLayoutId id="2147483672" r:id="rId23"/>
  </p:sldLayoutIdLst>
  <p:hf hdr="0" dt="0"/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6125" userDrawn="1">
          <p15:clr>
            <a:srgbClr val="F26B43"/>
          </p15:clr>
        </p15:guide>
        <p15:guide id="2" pos="367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11E597B7-D2A8-3CC1-C0BF-A19239073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1</a:t>
            </a:fld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8305831-7DDA-08BE-1133-49D5F828524B}"/>
              </a:ext>
            </a:extLst>
          </p:cNvPr>
          <p:cNvSpPr txBox="1"/>
          <p:nvPr/>
        </p:nvSpPr>
        <p:spPr>
          <a:xfrm>
            <a:off x="2497535" y="-82444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l Figure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B7FD8B8-AFCB-DAFC-78E4-B4A7DDA9E76E}"/>
              </a:ext>
            </a:extLst>
          </p:cNvPr>
          <p:cNvSpPr txBox="1"/>
          <p:nvPr/>
        </p:nvSpPr>
        <p:spPr>
          <a:xfrm>
            <a:off x="-19045" y="295486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(A)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21CD9A1-16D1-E5C9-A756-A383044E71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8622670"/>
              </p:ext>
            </p:extLst>
          </p:nvPr>
        </p:nvGraphicFramePr>
        <p:xfrm>
          <a:off x="161227" y="6014232"/>
          <a:ext cx="7457503" cy="1581212"/>
        </p:xfrm>
        <a:graphic>
          <a:graphicData uri="http://schemas.openxmlformats.org/drawingml/2006/table">
            <a:tbl>
              <a:tblPr/>
              <a:tblGrid>
                <a:gridCol w="1238363">
                  <a:extLst>
                    <a:ext uri="{9D8B030D-6E8A-4147-A177-3AD203B41FA5}">
                      <a16:colId xmlns:a16="http://schemas.microsoft.com/office/drawing/2014/main" val="1914404836"/>
                    </a:ext>
                  </a:extLst>
                </a:gridCol>
                <a:gridCol w="1056042">
                  <a:extLst>
                    <a:ext uri="{9D8B030D-6E8A-4147-A177-3AD203B41FA5}">
                      <a16:colId xmlns:a16="http://schemas.microsoft.com/office/drawing/2014/main" val="424426236"/>
                    </a:ext>
                  </a:extLst>
                </a:gridCol>
                <a:gridCol w="1221299">
                  <a:extLst>
                    <a:ext uri="{9D8B030D-6E8A-4147-A177-3AD203B41FA5}">
                      <a16:colId xmlns:a16="http://schemas.microsoft.com/office/drawing/2014/main" val="1324162275"/>
                    </a:ext>
                  </a:extLst>
                </a:gridCol>
                <a:gridCol w="965339">
                  <a:extLst>
                    <a:ext uri="{9D8B030D-6E8A-4147-A177-3AD203B41FA5}">
                      <a16:colId xmlns:a16="http://schemas.microsoft.com/office/drawing/2014/main" val="797428358"/>
                    </a:ext>
                  </a:extLst>
                </a:gridCol>
                <a:gridCol w="2976460">
                  <a:extLst>
                    <a:ext uri="{9D8B030D-6E8A-4147-A177-3AD203B41FA5}">
                      <a16:colId xmlns:a16="http://schemas.microsoft.com/office/drawing/2014/main" val="2041228175"/>
                    </a:ext>
                  </a:extLst>
                </a:gridCol>
              </a:tblGrid>
              <a:tr h="3318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L-18 SCA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edicted MW (Da)</a:t>
                      </a:r>
                    </a:p>
                    <a:p>
                      <a:pPr algn="ctr" fontAlgn="b"/>
                      <a:r>
                        <a:rPr lang="en-US" sz="900" b="1" i="0" u="none" strike="noStrike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s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reduced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bserved From LCMS Mw (Da)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bs-Pred. (Da)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mment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5677957"/>
                  </a:ext>
                </a:extLst>
              </a:tr>
              <a:tr h="1561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R3097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31.29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27.79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3.5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Confirmed, 2 disulfides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002903"/>
                  </a:ext>
                </a:extLst>
              </a:tr>
              <a:tr h="1561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1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22.35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16.81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5.54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Confirmed, 3 disulfides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6093473"/>
                  </a:ext>
                </a:extLst>
              </a:tr>
              <a:tr h="1561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11.25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745.9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34.65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+238 – 4 consistent with palmitoylation and 2 disulfides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91767092"/>
                  </a:ext>
                </a:extLst>
              </a:tr>
              <a:tr h="1561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3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53.33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47.72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5.61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Confirmed, 3 disulfides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3293808"/>
                  </a:ext>
                </a:extLst>
              </a:tr>
              <a:tr h="1561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4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35.35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29.82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5.53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Confirmed, 3 disulfides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522159"/>
                  </a:ext>
                </a:extLst>
              </a:tr>
              <a:tr h="1561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5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65.38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59.85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5.53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Confirmed, 3 disulfides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9750385"/>
                  </a:ext>
                </a:extLst>
              </a:tr>
              <a:tr h="1561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6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63.41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57.85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5.56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Confirmed, 3 disulfides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894461"/>
                  </a:ext>
                </a:extLst>
              </a:tr>
              <a:tr h="1561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7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49.38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6543.95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5.43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Confirmed, 3 disulfides</a:t>
                      </a:r>
                    </a:p>
                  </a:txBody>
                  <a:tcPr marL="7321" marR="7321" marT="73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9848665"/>
                  </a:ext>
                </a:extLst>
              </a:tr>
            </a:tbl>
          </a:graphicData>
        </a:graphic>
      </p:graphicFrame>
      <p:pic>
        <p:nvPicPr>
          <p:cNvPr id="7" name="Picture 6" descr="A graph of a mass&#10;&#10;Description automatically generated">
            <a:extLst>
              <a:ext uri="{FF2B5EF4-FFF2-40B4-BE49-F238E27FC236}">
                <a16:creationId xmlns:a16="http://schemas.microsoft.com/office/drawing/2014/main" id="{CBFFD177-195A-4512-FAF6-FA2255A6F2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1991" b="23727"/>
          <a:stretch/>
        </p:blipFill>
        <p:spPr>
          <a:xfrm>
            <a:off x="373411" y="634040"/>
            <a:ext cx="2395223" cy="1463690"/>
          </a:xfrm>
          <a:prstGeom prst="rect">
            <a:avLst/>
          </a:prstGeom>
        </p:spPr>
      </p:pic>
      <p:pic>
        <p:nvPicPr>
          <p:cNvPr id="8" name="Picture 7" descr="A graph of a person's body&#10;&#10;Description automatically generated with medium confidence">
            <a:extLst>
              <a:ext uri="{FF2B5EF4-FFF2-40B4-BE49-F238E27FC236}">
                <a16:creationId xmlns:a16="http://schemas.microsoft.com/office/drawing/2014/main" id="{42D613E6-F583-F985-29A6-F88F07A2AF0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3975"/>
          <a:stretch/>
        </p:blipFill>
        <p:spPr>
          <a:xfrm>
            <a:off x="2881281" y="628866"/>
            <a:ext cx="2351556" cy="1463690"/>
          </a:xfrm>
          <a:prstGeom prst="rect">
            <a:avLst/>
          </a:prstGeom>
        </p:spPr>
      </p:pic>
      <p:pic>
        <p:nvPicPr>
          <p:cNvPr id="9" name="Picture 8" descr="A screen shot of a graph&#10;&#10;Description automatically generated">
            <a:extLst>
              <a:ext uri="{FF2B5EF4-FFF2-40B4-BE49-F238E27FC236}">
                <a16:creationId xmlns:a16="http://schemas.microsoft.com/office/drawing/2014/main" id="{DC5A58B1-18A7-042C-3F3B-3E3F9AE8C34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3235"/>
          <a:stretch/>
        </p:blipFill>
        <p:spPr>
          <a:xfrm>
            <a:off x="5330158" y="614024"/>
            <a:ext cx="2334168" cy="1463690"/>
          </a:xfrm>
          <a:prstGeom prst="rect">
            <a:avLst/>
          </a:prstGeom>
        </p:spPr>
      </p:pic>
      <p:pic>
        <p:nvPicPr>
          <p:cNvPr id="10" name="Picture 9" descr="A graph of a number&#10;&#10;Description automatically generated with medium confidence">
            <a:extLst>
              <a:ext uri="{FF2B5EF4-FFF2-40B4-BE49-F238E27FC236}">
                <a16:creationId xmlns:a16="http://schemas.microsoft.com/office/drawing/2014/main" id="{138EA378-D5A4-1CE2-E9E7-9FD5275EB10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b="3951"/>
          <a:stretch/>
        </p:blipFill>
        <p:spPr>
          <a:xfrm>
            <a:off x="380637" y="2250129"/>
            <a:ext cx="2395906" cy="1481098"/>
          </a:xfrm>
          <a:prstGeom prst="rect">
            <a:avLst/>
          </a:prstGeom>
        </p:spPr>
      </p:pic>
      <p:pic>
        <p:nvPicPr>
          <p:cNvPr id="11" name="Picture 10" descr="A graph of a number of objects&#10;&#10;Description automatically generated with medium confidence">
            <a:extLst>
              <a:ext uri="{FF2B5EF4-FFF2-40B4-BE49-F238E27FC236}">
                <a16:creationId xmlns:a16="http://schemas.microsoft.com/office/drawing/2014/main" id="{5CAB3364-95C7-33E1-980D-5352D6DAC8E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b="3627"/>
          <a:stretch/>
        </p:blipFill>
        <p:spPr>
          <a:xfrm>
            <a:off x="2881281" y="2254923"/>
            <a:ext cx="2395223" cy="1481476"/>
          </a:xfrm>
          <a:prstGeom prst="rect">
            <a:avLst/>
          </a:prstGeom>
        </p:spPr>
      </p:pic>
      <p:pic>
        <p:nvPicPr>
          <p:cNvPr id="12" name="Picture 11" descr="A graph of a mass&#10;&#10;Description automatically generated with medium confidence">
            <a:extLst>
              <a:ext uri="{FF2B5EF4-FFF2-40B4-BE49-F238E27FC236}">
                <a16:creationId xmlns:a16="http://schemas.microsoft.com/office/drawing/2014/main" id="{11724819-4C2F-8E6B-975C-374E3E771434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b="3652"/>
          <a:stretch/>
        </p:blipFill>
        <p:spPr>
          <a:xfrm>
            <a:off x="5340896" y="2223626"/>
            <a:ext cx="2350432" cy="1481098"/>
          </a:xfrm>
          <a:prstGeom prst="rect">
            <a:avLst/>
          </a:prstGeom>
        </p:spPr>
      </p:pic>
      <p:pic>
        <p:nvPicPr>
          <p:cNvPr id="13" name="Picture 12" descr="A screen shot of a graph&#10;&#10;Description automatically generated">
            <a:extLst>
              <a:ext uri="{FF2B5EF4-FFF2-40B4-BE49-F238E27FC236}">
                <a16:creationId xmlns:a16="http://schemas.microsoft.com/office/drawing/2014/main" id="{7B70F89F-5842-3D8A-B23E-33ED5738EE01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b="3191"/>
          <a:stretch/>
        </p:blipFill>
        <p:spPr>
          <a:xfrm>
            <a:off x="373410" y="3876746"/>
            <a:ext cx="2395223" cy="1504940"/>
          </a:xfrm>
          <a:prstGeom prst="rect">
            <a:avLst/>
          </a:prstGeom>
        </p:spPr>
      </p:pic>
      <p:pic>
        <p:nvPicPr>
          <p:cNvPr id="14" name="Picture 13" descr="A green and black graph&#10;&#10;Description automatically generated">
            <a:extLst>
              <a:ext uri="{FF2B5EF4-FFF2-40B4-BE49-F238E27FC236}">
                <a16:creationId xmlns:a16="http://schemas.microsoft.com/office/drawing/2014/main" id="{A39F6CBC-66DE-74EF-0421-7051AC401349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b="4680"/>
          <a:stretch/>
        </p:blipFill>
        <p:spPr>
          <a:xfrm>
            <a:off x="2881281" y="3876746"/>
            <a:ext cx="2351555" cy="145731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ABF7AFD-003D-784D-013A-9C9133D74299}"/>
              </a:ext>
            </a:extLst>
          </p:cNvPr>
          <p:cNvSpPr txBox="1"/>
          <p:nvPr/>
        </p:nvSpPr>
        <p:spPr>
          <a:xfrm>
            <a:off x="3086709" y="731446"/>
            <a:ext cx="632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S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BBA079D-151A-BB5A-91BD-F4C719DA1DB4}"/>
              </a:ext>
            </a:extLst>
          </p:cNvPr>
          <p:cNvSpPr txBox="1"/>
          <p:nvPr/>
        </p:nvSpPr>
        <p:spPr>
          <a:xfrm>
            <a:off x="5477043" y="650143"/>
            <a:ext cx="632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S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90BE636-9CC0-30FB-A1A4-7173E80C8FEF}"/>
              </a:ext>
            </a:extLst>
          </p:cNvPr>
          <p:cNvSpPr txBox="1"/>
          <p:nvPr/>
        </p:nvSpPr>
        <p:spPr>
          <a:xfrm>
            <a:off x="555638" y="2352954"/>
            <a:ext cx="632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S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E253228-12FC-15E8-A840-3BC8415FA890}"/>
              </a:ext>
            </a:extLst>
          </p:cNvPr>
          <p:cNvSpPr txBox="1"/>
          <p:nvPr/>
        </p:nvSpPr>
        <p:spPr>
          <a:xfrm>
            <a:off x="3056991" y="2310007"/>
            <a:ext cx="632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S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685BC90-BD6A-D873-7234-0009548F104B}"/>
              </a:ext>
            </a:extLst>
          </p:cNvPr>
          <p:cNvSpPr txBox="1"/>
          <p:nvPr/>
        </p:nvSpPr>
        <p:spPr>
          <a:xfrm>
            <a:off x="5490992" y="2283502"/>
            <a:ext cx="632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S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152CF97-C5D3-332C-9A9C-4A54E71CBE02}"/>
              </a:ext>
            </a:extLst>
          </p:cNvPr>
          <p:cNvSpPr txBox="1"/>
          <p:nvPr/>
        </p:nvSpPr>
        <p:spPr>
          <a:xfrm>
            <a:off x="555638" y="4005392"/>
            <a:ext cx="632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S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6EEAE55-59BD-1E63-83C3-1E958804C54D}"/>
              </a:ext>
            </a:extLst>
          </p:cNvPr>
          <p:cNvSpPr txBox="1"/>
          <p:nvPr/>
        </p:nvSpPr>
        <p:spPr>
          <a:xfrm>
            <a:off x="3053295" y="3997800"/>
            <a:ext cx="550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S7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9031DAB-27D6-555E-9FFA-886411B460F4}"/>
              </a:ext>
            </a:extLst>
          </p:cNvPr>
          <p:cNvSpPr txBox="1"/>
          <p:nvPr/>
        </p:nvSpPr>
        <p:spPr>
          <a:xfrm>
            <a:off x="555638" y="731446"/>
            <a:ext cx="1021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DR3097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4E546F0-4ABC-0214-B708-C9A2AA8AAB2A}"/>
              </a:ext>
            </a:extLst>
          </p:cNvPr>
          <p:cNvSpPr txBox="1"/>
          <p:nvPr/>
        </p:nvSpPr>
        <p:spPr>
          <a:xfrm>
            <a:off x="1724204" y="711398"/>
            <a:ext cx="1021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26527.7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C65C47A-F930-8D37-4C8A-9D52AFBD8918}"/>
              </a:ext>
            </a:extLst>
          </p:cNvPr>
          <p:cNvSpPr txBox="1"/>
          <p:nvPr/>
        </p:nvSpPr>
        <p:spPr>
          <a:xfrm>
            <a:off x="4087566" y="724335"/>
            <a:ext cx="1021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26516.8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B14025F-3D49-D48E-2C5E-94BD7B2A5150}"/>
              </a:ext>
            </a:extLst>
          </p:cNvPr>
          <p:cNvSpPr txBox="1"/>
          <p:nvPr/>
        </p:nvSpPr>
        <p:spPr>
          <a:xfrm>
            <a:off x="6376111" y="676240"/>
            <a:ext cx="1021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26745.9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B55511A-BFC9-F6D5-3BE9-BD93716FAD02}"/>
              </a:ext>
            </a:extLst>
          </p:cNvPr>
          <p:cNvSpPr txBox="1"/>
          <p:nvPr/>
        </p:nvSpPr>
        <p:spPr>
          <a:xfrm>
            <a:off x="1251257" y="2338610"/>
            <a:ext cx="1021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26547.7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79D5125-0F68-9965-B0A6-82042B9C3160}"/>
              </a:ext>
            </a:extLst>
          </p:cNvPr>
          <p:cNvSpPr txBox="1"/>
          <p:nvPr/>
        </p:nvSpPr>
        <p:spPr>
          <a:xfrm>
            <a:off x="3892013" y="2319387"/>
            <a:ext cx="1021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26529.8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8087681-8036-B77F-15B8-DC6FDAEB8B4D}"/>
              </a:ext>
            </a:extLst>
          </p:cNvPr>
          <p:cNvSpPr txBox="1"/>
          <p:nvPr/>
        </p:nvSpPr>
        <p:spPr>
          <a:xfrm>
            <a:off x="6396587" y="2356900"/>
            <a:ext cx="1021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26559.8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483D59D-EEB9-BE18-7F4C-A6049D33110B}"/>
              </a:ext>
            </a:extLst>
          </p:cNvPr>
          <p:cNvSpPr txBox="1"/>
          <p:nvPr/>
        </p:nvSpPr>
        <p:spPr>
          <a:xfrm>
            <a:off x="1643802" y="3980966"/>
            <a:ext cx="1021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26557.85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A713134-838E-B155-51AF-83DE83F81D44}"/>
              </a:ext>
            </a:extLst>
          </p:cNvPr>
          <p:cNvSpPr txBox="1"/>
          <p:nvPr/>
        </p:nvSpPr>
        <p:spPr>
          <a:xfrm>
            <a:off x="4066744" y="4005392"/>
            <a:ext cx="1021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26543.9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E75F0A7-3480-1669-454A-56560DB10EBE}"/>
              </a:ext>
            </a:extLst>
          </p:cNvPr>
          <p:cNvSpPr txBox="1"/>
          <p:nvPr/>
        </p:nvSpPr>
        <p:spPr>
          <a:xfrm>
            <a:off x="3209156" y="5510090"/>
            <a:ext cx="21712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Deconvoluted Mass (Da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CD41BF3-C5D8-FA1A-DFE2-0C8A82BCBDCB}"/>
              </a:ext>
            </a:extLst>
          </p:cNvPr>
          <p:cNvSpPr txBox="1"/>
          <p:nvPr/>
        </p:nvSpPr>
        <p:spPr>
          <a:xfrm rot="16200000">
            <a:off x="-280040" y="2704260"/>
            <a:ext cx="841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Counts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04FA4175-C18C-5D10-C259-86F99ACCE762}"/>
              </a:ext>
            </a:extLst>
          </p:cNvPr>
          <p:cNvCxnSpPr/>
          <p:nvPr/>
        </p:nvCxnSpPr>
        <p:spPr>
          <a:xfrm>
            <a:off x="287341" y="628866"/>
            <a:ext cx="0" cy="480242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06136729-F773-939D-60A5-5F6AB5E7B3C7}"/>
              </a:ext>
            </a:extLst>
          </p:cNvPr>
          <p:cNvCxnSpPr>
            <a:cxnSpLocks/>
          </p:cNvCxnSpPr>
          <p:nvPr/>
        </p:nvCxnSpPr>
        <p:spPr>
          <a:xfrm flipH="1">
            <a:off x="373410" y="5461766"/>
            <a:ext cx="729091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A2C47098-83A7-0408-3299-458D2C3C1516}"/>
              </a:ext>
            </a:extLst>
          </p:cNvPr>
          <p:cNvSpPr txBox="1"/>
          <p:nvPr/>
        </p:nvSpPr>
        <p:spPr>
          <a:xfrm>
            <a:off x="0" y="5764573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/>
              <a:t>(B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FA2EDBE-C145-1937-37C6-8641EAE00D64}"/>
              </a:ext>
            </a:extLst>
          </p:cNvPr>
          <p:cNvSpPr txBox="1"/>
          <p:nvPr/>
        </p:nvSpPr>
        <p:spPr>
          <a:xfrm>
            <a:off x="48003" y="7749322"/>
            <a:ext cx="7772400" cy="22511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9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Supplemental Figure 1: LCMS confirms disulfide bond formation for six out of seven engineered, stapled DR3097 SCAs.</a:t>
            </a:r>
            <a:r>
              <a:rPr lang="en-US" sz="9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 </a:t>
            </a:r>
            <a:r>
              <a:rPr lang="en-US" sz="9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A)</a:t>
            </a:r>
            <a:r>
              <a:rPr lang="en-US" sz="9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 Deconvoluted mass spectra show experimentally determined molecular weights of DR3097 and stapled DR3097 S1-S7. </a:t>
            </a:r>
            <a:r>
              <a:rPr lang="en-US" sz="9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B</a:t>
            </a:r>
            <a:r>
              <a:rPr lang="en-US" sz="9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) Summary table of experimentally observed molecular weights in A) vs calculated (predicted) molecular weights based on amino acid sequence with all </a:t>
            </a:r>
            <a:r>
              <a:rPr lang="en-US" sz="9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cysteins</a:t>
            </a:r>
            <a:r>
              <a:rPr lang="en-US" sz="9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 being reduced. The differences between observed and predicted (</a:t>
            </a:r>
            <a:r>
              <a:rPr lang="en-US" sz="9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Obs</a:t>
            </a:r>
            <a:r>
              <a:rPr lang="en-US" sz="9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-Pred.) indicate the number of protons lost through disulfide bonding. Unstapled DR3097 features two disulfide bonds which are confirmed by the </a:t>
            </a:r>
            <a:r>
              <a:rPr lang="en-US" sz="9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Obs</a:t>
            </a:r>
            <a:r>
              <a:rPr lang="en-US" sz="9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-Pred. value near 4 Da. </a:t>
            </a:r>
            <a:r>
              <a:rPr lang="en-US" sz="9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Obs</a:t>
            </a:r>
            <a:r>
              <a:rPr lang="en-US" sz="9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-Pred. values near 6 Da show the formation of an additional, stapled disulfide bond.  </a:t>
            </a:r>
            <a:endParaRPr lang="en-US" sz="900" dirty="0">
              <a:effectLst/>
              <a:latin typeface="Aptos" panose="020B0004020202020204" pitchFamily="34" charset="0"/>
              <a:ea typeface="Aptos" panose="020B0004020202020204" pitchFamily="34" charset="0"/>
              <a:cs typeface="Aptos" panose="020B0004020202020204" pitchFamily="34" charset="0"/>
            </a:endParaRPr>
          </a:p>
          <a:p>
            <a:pPr marL="0" marR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9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Supplemental Figure 1 Alt Text: 2 panel figure A-B. A)</a:t>
            </a:r>
            <a:r>
              <a:rPr lang="en-US" sz="9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 LCMS deconvoluted mass spectra for DR3097 and stapled variants S1-S7 showing the molecular weight of each protein. Each graph features one major peak indicating the presence of one homogenous mass species. </a:t>
            </a:r>
            <a:r>
              <a:rPr lang="en-US" sz="9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B</a:t>
            </a:r>
            <a:r>
              <a:rPr lang="en-US" sz="9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ptos" panose="020B0004020202020204" pitchFamily="34" charset="0"/>
              </a:rPr>
              <a:t>) A table summarizes observed and predicted molecular weights of fully reduced proteins. All staples except S2 have a mass differences observed-predicted of ~6 Da compared to 4 Da in DR3097 indicating formation of an additional disulfide bond (loss of two protons). </a:t>
            </a:r>
            <a:endParaRPr lang="en-US" sz="900" dirty="0">
              <a:effectLst/>
              <a:latin typeface="Aptos" panose="020B0004020202020204" pitchFamily="34" charset="0"/>
              <a:ea typeface="Aptos" panose="020B0004020202020204" pitchFamily="34" charset="0"/>
              <a:cs typeface="Aptos" panose="020B00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6772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6D66C487B8524A912F69BFA19801DE" ma:contentTypeVersion="11" ma:contentTypeDescription="Create a new document." ma:contentTypeScope="" ma:versionID="d753091baa5679cc90ce7051d3409a17">
  <xsd:schema xmlns:xsd="http://www.w3.org/2001/XMLSchema" xmlns:xs="http://www.w3.org/2001/XMLSchema" xmlns:p="http://schemas.microsoft.com/office/2006/metadata/properties" xmlns:ns2="6798995b-4357-417e-b2b0-e6a0466ce260" xmlns:ns3="512ef481-89e2-48a7-848f-395bc26523f6" targetNamespace="http://schemas.microsoft.com/office/2006/metadata/properties" ma:root="true" ma:fieldsID="a244202f1d3d341dcb69996461af8795" ns2:_="" ns3:_="">
    <xsd:import namespace="6798995b-4357-417e-b2b0-e6a0466ce260"/>
    <xsd:import namespace="512ef481-89e2-48a7-848f-395bc26523f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798995b-4357-417e-b2b0-e6a0466ce26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6df76642-5dee-44d1-b3dd-94c4a7bc001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12ef481-89e2-48a7-848f-395bc26523f6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976b1953-0d22-4a90-8b0f-ba060d18c260}" ma:internalName="TaxCatchAll" ma:showField="CatchAllData" ma:web="512ef481-89e2-48a7-848f-395bc26523f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512ef481-89e2-48a7-848f-395bc26523f6" xsi:nil="true"/>
    <lcf76f155ced4ddcb4097134ff3c332f xmlns="6798995b-4357-417e-b2b0-e6a0466ce260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303D5040-AFB2-4027-9DD0-4B6416C70FB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44CC6627-F653-4F2E-BD30-9C0818F3D094}">
  <ds:schemaRefs>
    <ds:schemaRef ds:uri="512ef481-89e2-48a7-848f-395bc26523f6"/>
    <ds:schemaRef ds:uri="6798995b-4357-417e-b2b0-e6a0466ce260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E7398FE2-407B-4152-976C-348F3F37B863}">
  <ds:schemaRefs>
    <ds:schemaRef ds:uri="http://schemas.microsoft.com/office/infopath/2007/PartnerControls"/>
    <ds:schemaRef ds:uri="http://purl.org/dc/terms/"/>
    <ds:schemaRef ds:uri="http://schemas.microsoft.com/office/2006/documentManagement/types"/>
    <ds:schemaRef ds:uri="http://purl.org/dc/dcmitype/"/>
    <ds:schemaRef ds:uri="512ef481-89e2-48a7-848f-395bc26523f6"/>
    <ds:schemaRef ds:uri="6798995b-4357-417e-b2b0-e6a0466ce260"/>
    <ds:schemaRef ds:uri="http://purl.org/dc/elements/1.1/"/>
    <ds:schemaRef ds:uri="http://schemas.openxmlformats.org/package/2006/metadata/core-properties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2</TotalTime>
  <Words>345</Words>
  <Application>Microsoft Office PowerPoint</Application>
  <PresentationFormat>Custom</PresentationFormat>
  <Paragraphs>7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rial</vt:lpstr>
      <vt:lpstr>Calibri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 C</dc:creator>
  <cp:lastModifiedBy>sandro vivona</cp:lastModifiedBy>
  <cp:revision>16</cp:revision>
  <cp:lastPrinted>2025-04-18T07:16:31Z</cp:lastPrinted>
  <dcterms:created xsi:type="dcterms:W3CDTF">2021-07-12T13:03:00Z</dcterms:created>
  <dcterms:modified xsi:type="dcterms:W3CDTF">2025-08-27T06:36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6D66C487B8524A912F69BFA19801DE</vt:lpwstr>
  </property>
  <property fmtid="{D5CDD505-2E9C-101B-9397-08002B2CF9AE}" pid="3" name="MediaServiceImageTags">
    <vt:lpwstr/>
  </property>
</Properties>
</file>